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D390B-B239-439E-A8A6-DC92925ECC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AC849-A029-4AA9-9CD3-795F0BE980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1B240-661A-41F7-BA35-AD02358327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FE97F-4E91-4CDD-98DD-7EC76ABEF2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5A4CC-B608-4B0F-9374-DB6CB176BE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738B6-5D39-4D3C-8EE7-47C5F637D3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A831D-ECD3-41F9-BD5E-E1C56D46BE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01E82-558B-497E-8A91-0B44EEBD00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82EA9-5691-4EB4-9AD1-49830A4A79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EE97C-A599-42FB-BBD7-38CA43C238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964A2-BA63-4A79-9599-76009DF41D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7D459-407D-4F36-B4D9-485BD0E94B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DE4F72-3D02-46DE-B3DF-705F59ED0880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13"/>
          <p:cNvSpPr/>
          <p:nvPr/>
        </p:nvSpPr>
        <p:spPr>
          <a:xfrm>
            <a:off x="2620800" y="1114560"/>
            <a:ext cx="5040" cy="34920"/>
          </a:xfrm>
          <a:prstGeom prst="rect">
            <a:avLst/>
          </a:prstGeom>
          <a:solidFill>
            <a:srgbClr val="ffffcc"/>
          </a:solidFill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214"/>
          <p:cNvSpPr/>
          <p:nvPr/>
        </p:nvSpPr>
        <p:spPr>
          <a:xfrm>
            <a:off x="2482920" y="1114560"/>
            <a:ext cx="4356000" cy="3492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Freeform 217"/>
          <p:cNvSpPr/>
          <p:nvPr/>
        </p:nvSpPr>
        <p:spPr>
          <a:xfrm>
            <a:off x="3209760" y="1015920"/>
            <a:ext cx="1019520" cy="233280"/>
          </a:xfrm>
          <a:custGeom>
            <a:avLst/>
            <a:gdLst>
              <a:gd name="textAreaLeft" fmla="*/ 0 w 1019520"/>
              <a:gd name="textAreaRight" fmla="*/ 1019880 w 101952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690" h="147">
                <a:moveTo>
                  <a:pt x="624" y="147"/>
                </a:moveTo>
                <a:lnTo>
                  <a:pt x="690" y="73"/>
                </a:lnTo>
                <a:lnTo>
                  <a:pt x="624" y="0"/>
                </a:lnTo>
                <a:lnTo>
                  <a:pt x="624" y="33"/>
                </a:lnTo>
                <a:lnTo>
                  <a:pt x="0" y="33"/>
                </a:lnTo>
                <a:lnTo>
                  <a:pt x="0" y="114"/>
                </a:lnTo>
                <a:lnTo>
                  <a:pt x="624" y="114"/>
                </a:lnTo>
                <a:lnTo>
                  <a:pt x="624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19"/>
          <p:cNvSpPr/>
          <p:nvPr/>
        </p:nvSpPr>
        <p:spPr>
          <a:xfrm>
            <a:off x="3619800" y="1066680"/>
            <a:ext cx="291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3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Freeform 220"/>
          <p:cNvSpPr/>
          <p:nvPr/>
        </p:nvSpPr>
        <p:spPr>
          <a:xfrm>
            <a:off x="4489560" y="1011240"/>
            <a:ext cx="774720" cy="233280"/>
          </a:xfrm>
          <a:custGeom>
            <a:avLst/>
            <a:gdLst>
              <a:gd name="textAreaLeft" fmla="*/ 0 w 774720"/>
              <a:gd name="textAreaRight" fmla="*/ 775080 w 77472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525" h="147">
                <a:moveTo>
                  <a:pt x="459" y="147"/>
                </a:moveTo>
                <a:lnTo>
                  <a:pt x="525" y="73"/>
                </a:lnTo>
                <a:lnTo>
                  <a:pt x="459" y="0"/>
                </a:lnTo>
                <a:lnTo>
                  <a:pt x="459" y="33"/>
                </a:lnTo>
                <a:lnTo>
                  <a:pt x="0" y="33"/>
                </a:lnTo>
                <a:lnTo>
                  <a:pt x="0" y="114"/>
                </a:lnTo>
                <a:lnTo>
                  <a:pt x="459" y="114"/>
                </a:lnTo>
                <a:lnTo>
                  <a:pt x="459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22"/>
          <p:cNvSpPr/>
          <p:nvPr/>
        </p:nvSpPr>
        <p:spPr>
          <a:xfrm>
            <a:off x="4732920" y="10555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223"/>
          <p:cNvSpPr/>
          <p:nvPr/>
        </p:nvSpPr>
        <p:spPr>
          <a:xfrm>
            <a:off x="5307120" y="1015920"/>
            <a:ext cx="576000" cy="233280"/>
          </a:xfrm>
          <a:custGeom>
            <a:avLst/>
            <a:gdLst>
              <a:gd name="textAreaLeft" fmla="*/ 0 w 576000"/>
              <a:gd name="textAreaRight" fmla="*/ 576000 w 57600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90" h="147">
                <a:moveTo>
                  <a:pt x="324" y="147"/>
                </a:moveTo>
                <a:lnTo>
                  <a:pt x="390" y="73"/>
                </a:lnTo>
                <a:lnTo>
                  <a:pt x="324" y="0"/>
                </a:lnTo>
                <a:lnTo>
                  <a:pt x="324" y="33"/>
                </a:lnTo>
                <a:lnTo>
                  <a:pt x="0" y="33"/>
                </a:lnTo>
                <a:lnTo>
                  <a:pt x="0" y="114"/>
                </a:lnTo>
                <a:lnTo>
                  <a:pt x="324" y="114"/>
                </a:lnTo>
                <a:lnTo>
                  <a:pt x="324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225"/>
          <p:cNvSpPr/>
          <p:nvPr/>
        </p:nvSpPr>
        <p:spPr>
          <a:xfrm>
            <a:off x="5451840" y="10699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reeform 226"/>
          <p:cNvSpPr/>
          <p:nvPr/>
        </p:nvSpPr>
        <p:spPr>
          <a:xfrm>
            <a:off x="5924520" y="1015920"/>
            <a:ext cx="182520" cy="233280"/>
          </a:xfrm>
          <a:custGeom>
            <a:avLst/>
            <a:gdLst>
              <a:gd name="textAreaLeft" fmla="*/ 0 w 182520"/>
              <a:gd name="textAreaRight" fmla="*/ 182880 w 18252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124" h="147">
                <a:moveTo>
                  <a:pt x="59" y="147"/>
                </a:moveTo>
                <a:lnTo>
                  <a:pt x="124" y="73"/>
                </a:lnTo>
                <a:lnTo>
                  <a:pt x="59" y="0"/>
                </a:lnTo>
                <a:lnTo>
                  <a:pt x="59" y="33"/>
                </a:lnTo>
                <a:lnTo>
                  <a:pt x="0" y="33"/>
                </a:lnTo>
                <a:lnTo>
                  <a:pt x="0" y="114"/>
                </a:lnTo>
                <a:lnTo>
                  <a:pt x="59" y="114"/>
                </a:lnTo>
                <a:lnTo>
                  <a:pt x="59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28"/>
          <p:cNvSpPr/>
          <p:nvPr/>
        </p:nvSpPr>
        <p:spPr>
          <a:xfrm>
            <a:off x="5895000" y="12286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f4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Freeform 229"/>
          <p:cNvSpPr/>
          <p:nvPr/>
        </p:nvSpPr>
        <p:spPr>
          <a:xfrm rot="10800000">
            <a:off x="4332240" y="1015920"/>
            <a:ext cx="28800" cy="233280"/>
          </a:xfrm>
          <a:custGeom>
            <a:avLst/>
            <a:gdLst>
              <a:gd name="textAreaLeft" fmla="*/ 0 w 28800"/>
              <a:gd name="textAreaRight" fmla="*/ 29160 w 2880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1" h="147">
                <a:moveTo>
                  <a:pt x="8" y="147"/>
                </a:moveTo>
                <a:lnTo>
                  <a:pt x="31" y="73"/>
                </a:lnTo>
                <a:lnTo>
                  <a:pt x="8" y="0"/>
                </a:lnTo>
                <a:lnTo>
                  <a:pt x="8" y="33"/>
                </a:lnTo>
                <a:lnTo>
                  <a:pt x="0" y="33"/>
                </a:lnTo>
                <a:lnTo>
                  <a:pt x="0" y="114"/>
                </a:lnTo>
                <a:lnTo>
                  <a:pt x="8" y="114"/>
                </a:lnTo>
                <a:lnTo>
                  <a:pt x="8" y="147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0d0d0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31"/>
          <p:cNvSpPr/>
          <p:nvPr/>
        </p:nvSpPr>
        <p:spPr>
          <a:xfrm>
            <a:off x="4247280" y="86832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232"/>
          <p:cNvSpPr/>
          <p:nvPr/>
        </p:nvSpPr>
        <p:spPr>
          <a:xfrm>
            <a:off x="2879640" y="1014480"/>
            <a:ext cx="330120" cy="234720"/>
          </a:xfrm>
          <a:custGeom>
            <a:avLst/>
            <a:gdLst>
              <a:gd name="textAreaLeft" fmla="*/ 0 w 330120"/>
              <a:gd name="textAreaRight" fmla="*/ 330480 w 330120"/>
              <a:gd name="textAreaTop" fmla="*/ 0 h 234720"/>
              <a:gd name="textAreaBottom" fmla="*/ 235080 h 234720"/>
            </a:gdLst>
            <a:ahLst/>
            <a:rect l="textAreaLeft" t="textAreaTop" r="textAreaRight" b="textAreaBottom"/>
            <a:pathLst>
              <a:path w="224" h="148">
                <a:moveTo>
                  <a:pt x="158" y="148"/>
                </a:moveTo>
                <a:lnTo>
                  <a:pt x="224" y="74"/>
                </a:lnTo>
                <a:lnTo>
                  <a:pt x="158" y="0"/>
                </a:lnTo>
                <a:lnTo>
                  <a:pt x="158" y="33"/>
                </a:lnTo>
                <a:lnTo>
                  <a:pt x="0" y="33"/>
                </a:lnTo>
                <a:lnTo>
                  <a:pt x="0" y="115"/>
                </a:lnTo>
                <a:lnTo>
                  <a:pt x="158" y="115"/>
                </a:lnTo>
                <a:lnTo>
                  <a:pt x="158" y="148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34"/>
          <p:cNvSpPr/>
          <p:nvPr/>
        </p:nvSpPr>
        <p:spPr>
          <a:xfrm>
            <a:off x="2889720" y="105876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手繪多邊形 359"/>
          <p:cNvSpPr/>
          <p:nvPr/>
        </p:nvSpPr>
        <p:spPr>
          <a:xfrm>
            <a:off x="3478320" y="1952640"/>
            <a:ext cx="1665360" cy="1116000"/>
          </a:xfrm>
          <a:custGeom>
            <a:avLst/>
            <a:gdLst/>
            <a:ahLst/>
            <a:rect l="l" t="t" r="r" b="b"/>
            <a:pathLst>
              <a:path w="1664141" h="1115999">
                <a:moveTo>
                  <a:pt x="322603" y="237458"/>
                </a:moveTo>
                <a:cubicBezTo>
                  <a:pt x="361499" y="179113"/>
                  <a:pt x="330311" y="213971"/>
                  <a:pt x="448109" y="174705"/>
                </a:cubicBezTo>
                <a:lnTo>
                  <a:pt x="501897" y="156776"/>
                </a:lnTo>
                <a:cubicBezTo>
                  <a:pt x="525274" y="148984"/>
                  <a:pt x="549709" y="144823"/>
                  <a:pt x="573615" y="138846"/>
                </a:cubicBezTo>
                <a:cubicBezTo>
                  <a:pt x="582782" y="136554"/>
                  <a:pt x="591544" y="132870"/>
                  <a:pt x="600509" y="129882"/>
                </a:cubicBezTo>
                <a:cubicBezTo>
                  <a:pt x="609474" y="123905"/>
                  <a:pt x="618636" y="118214"/>
                  <a:pt x="627403" y="111952"/>
                </a:cubicBezTo>
                <a:cubicBezTo>
                  <a:pt x="639561" y="103268"/>
                  <a:pt x="650289" y="92471"/>
                  <a:pt x="663262" y="85058"/>
                </a:cubicBezTo>
                <a:cubicBezTo>
                  <a:pt x="671467" y="80370"/>
                  <a:pt x="681191" y="79081"/>
                  <a:pt x="690156" y="76093"/>
                </a:cubicBezTo>
                <a:cubicBezTo>
                  <a:pt x="702109" y="67128"/>
                  <a:pt x="711092" y="49945"/>
                  <a:pt x="726015" y="49199"/>
                </a:cubicBezTo>
                <a:cubicBezTo>
                  <a:pt x="846547" y="43173"/>
                  <a:pt x="980521" y="0"/>
                  <a:pt x="1075638" y="76093"/>
                </a:cubicBezTo>
                <a:cubicBezTo>
                  <a:pt x="1082238" y="81373"/>
                  <a:pt x="1087591" y="88046"/>
                  <a:pt x="1093568" y="94023"/>
                </a:cubicBezTo>
                <a:cubicBezTo>
                  <a:pt x="1096556" y="102988"/>
                  <a:pt x="1103868" y="111562"/>
                  <a:pt x="1102532" y="120917"/>
                </a:cubicBezTo>
                <a:cubicBezTo>
                  <a:pt x="1092156" y="193546"/>
                  <a:pt x="1025108" y="152199"/>
                  <a:pt x="968062" y="147811"/>
                </a:cubicBezTo>
                <a:cubicBezTo>
                  <a:pt x="965074" y="138846"/>
                  <a:pt x="957544" y="130238"/>
                  <a:pt x="959097" y="120917"/>
                </a:cubicBezTo>
                <a:cubicBezTo>
                  <a:pt x="960249" y="114006"/>
                  <a:pt x="986247" y="80447"/>
                  <a:pt x="994956" y="76093"/>
                </a:cubicBezTo>
                <a:cubicBezTo>
                  <a:pt x="1011860" y="67641"/>
                  <a:pt x="1048744" y="58164"/>
                  <a:pt x="1048744" y="58164"/>
                </a:cubicBezTo>
                <a:cubicBezTo>
                  <a:pt x="1136525" y="63041"/>
                  <a:pt x="1182399" y="57960"/>
                  <a:pt x="1254932" y="76093"/>
                </a:cubicBezTo>
                <a:cubicBezTo>
                  <a:pt x="1317586" y="91756"/>
                  <a:pt x="1240731" y="77336"/>
                  <a:pt x="1317685" y="102987"/>
                </a:cubicBezTo>
                <a:cubicBezTo>
                  <a:pt x="1368801" y="120026"/>
                  <a:pt x="1352408" y="103682"/>
                  <a:pt x="1398368" y="120917"/>
                </a:cubicBezTo>
                <a:cubicBezTo>
                  <a:pt x="1461238" y="144493"/>
                  <a:pt x="1409098" y="130765"/>
                  <a:pt x="1461121" y="156776"/>
                </a:cubicBezTo>
                <a:cubicBezTo>
                  <a:pt x="1469573" y="161002"/>
                  <a:pt x="1479050" y="162752"/>
                  <a:pt x="1488015" y="165740"/>
                </a:cubicBezTo>
                <a:cubicBezTo>
                  <a:pt x="1493991" y="171717"/>
                  <a:pt x="1502164" y="176110"/>
                  <a:pt x="1505944" y="183670"/>
                </a:cubicBezTo>
                <a:cubicBezTo>
                  <a:pt x="1520615" y="213013"/>
                  <a:pt x="1519045" y="250750"/>
                  <a:pt x="1488015" y="273317"/>
                </a:cubicBezTo>
                <a:cubicBezTo>
                  <a:pt x="1468086" y="287810"/>
                  <a:pt x="1440203" y="285270"/>
                  <a:pt x="1416297" y="291246"/>
                </a:cubicBezTo>
                <a:cubicBezTo>
                  <a:pt x="1386415" y="288258"/>
                  <a:pt x="1354932" y="292383"/>
                  <a:pt x="1326650" y="282282"/>
                </a:cubicBezTo>
                <a:cubicBezTo>
                  <a:pt x="1307628" y="275489"/>
                  <a:pt x="1284580" y="237107"/>
                  <a:pt x="1272862" y="219529"/>
                </a:cubicBezTo>
                <a:cubicBezTo>
                  <a:pt x="1275850" y="204588"/>
                  <a:pt x="1266952" y="178010"/>
                  <a:pt x="1281826" y="174705"/>
                </a:cubicBezTo>
                <a:cubicBezTo>
                  <a:pt x="1357460" y="157897"/>
                  <a:pt x="1410415" y="161034"/>
                  <a:pt x="1461121" y="201599"/>
                </a:cubicBezTo>
                <a:cubicBezTo>
                  <a:pt x="1467721" y="206879"/>
                  <a:pt x="1473770" y="212929"/>
                  <a:pt x="1479050" y="219529"/>
                </a:cubicBezTo>
                <a:cubicBezTo>
                  <a:pt x="1485780" y="227942"/>
                  <a:pt x="1491003" y="237458"/>
                  <a:pt x="1496979" y="246423"/>
                </a:cubicBezTo>
                <a:cubicBezTo>
                  <a:pt x="1491003" y="270329"/>
                  <a:pt x="1496474" y="300716"/>
                  <a:pt x="1479050" y="318140"/>
                </a:cubicBezTo>
                <a:cubicBezTo>
                  <a:pt x="1456292" y="340898"/>
                  <a:pt x="1419285" y="342046"/>
                  <a:pt x="1389403" y="353999"/>
                </a:cubicBezTo>
                <a:cubicBezTo>
                  <a:pt x="1362535" y="364746"/>
                  <a:pt x="1356402" y="363429"/>
                  <a:pt x="1326650" y="371929"/>
                </a:cubicBezTo>
                <a:cubicBezTo>
                  <a:pt x="1317564" y="374525"/>
                  <a:pt x="1308721" y="377905"/>
                  <a:pt x="1299756" y="380893"/>
                </a:cubicBezTo>
                <a:cubicBezTo>
                  <a:pt x="1266909" y="413740"/>
                  <a:pt x="1294601" y="392995"/>
                  <a:pt x="1228038" y="407787"/>
                </a:cubicBezTo>
                <a:cubicBezTo>
                  <a:pt x="1218813" y="409837"/>
                  <a:pt x="1210410" y="414899"/>
                  <a:pt x="1201144" y="416752"/>
                </a:cubicBezTo>
                <a:cubicBezTo>
                  <a:pt x="1180424" y="420896"/>
                  <a:pt x="1159309" y="422729"/>
                  <a:pt x="1138391" y="425717"/>
                </a:cubicBezTo>
                <a:cubicBezTo>
                  <a:pt x="1102532" y="422729"/>
                  <a:pt x="1066798" y="416752"/>
                  <a:pt x="1030815" y="416752"/>
                </a:cubicBezTo>
                <a:cubicBezTo>
                  <a:pt x="1019434" y="416752"/>
                  <a:pt x="963962" y="431224"/>
                  <a:pt x="950132" y="434682"/>
                </a:cubicBezTo>
                <a:cubicBezTo>
                  <a:pt x="932203" y="428705"/>
                  <a:pt x="912069" y="427236"/>
                  <a:pt x="896344" y="416752"/>
                </a:cubicBezTo>
                <a:cubicBezTo>
                  <a:pt x="883912" y="408464"/>
                  <a:pt x="879174" y="392237"/>
                  <a:pt x="869450" y="380893"/>
                </a:cubicBezTo>
                <a:cubicBezTo>
                  <a:pt x="860787" y="370787"/>
                  <a:pt x="831137" y="340290"/>
                  <a:pt x="815662" y="336070"/>
                </a:cubicBezTo>
                <a:cubicBezTo>
                  <a:pt x="792419" y="329731"/>
                  <a:pt x="767850" y="330093"/>
                  <a:pt x="743944" y="327105"/>
                </a:cubicBezTo>
                <a:cubicBezTo>
                  <a:pt x="711073" y="330093"/>
                  <a:pt x="664516" y="309212"/>
                  <a:pt x="645332" y="336070"/>
                </a:cubicBezTo>
                <a:cubicBezTo>
                  <a:pt x="627586" y="360914"/>
                  <a:pt x="651369" y="460936"/>
                  <a:pt x="672226" y="497435"/>
                </a:cubicBezTo>
                <a:cubicBezTo>
                  <a:pt x="676419" y="504773"/>
                  <a:pt x="684876" y="508764"/>
                  <a:pt x="690156" y="515364"/>
                </a:cubicBezTo>
                <a:cubicBezTo>
                  <a:pt x="696887" y="523777"/>
                  <a:pt x="701073" y="534078"/>
                  <a:pt x="708085" y="542258"/>
                </a:cubicBezTo>
                <a:cubicBezTo>
                  <a:pt x="719086" y="555093"/>
                  <a:pt x="743944" y="578117"/>
                  <a:pt x="743944" y="578117"/>
                </a:cubicBezTo>
                <a:cubicBezTo>
                  <a:pt x="821638" y="569152"/>
                  <a:pt x="901713" y="572311"/>
                  <a:pt x="977026" y="551223"/>
                </a:cubicBezTo>
                <a:cubicBezTo>
                  <a:pt x="981061" y="550093"/>
                  <a:pt x="960231" y="493385"/>
                  <a:pt x="959097" y="488470"/>
                </a:cubicBezTo>
                <a:cubicBezTo>
                  <a:pt x="952245" y="458776"/>
                  <a:pt x="947144" y="428705"/>
                  <a:pt x="941168" y="398823"/>
                </a:cubicBezTo>
                <a:cubicBezTo>
                  <a:pt x="939315" y="389557"/>
                  <a:pt x="936429" y="380381"/>
                  <a:pt x="932203" y="371929"/>
                </a:cubicBezTo>
                <a:cubicBezTo>
                  <a:pt x="899633" y="306791"/>
                  <a:pt x="929698" y="377138"/>
                  <a:pt x="896344" y="327105"/>
                </a:cubicBezTo>
                <a:cubicBezTo>
                  <a:pt x="881813" y="305307"/>
                  <a:pt x="883326" y="287021"/>
                  <a:pt x="860485" y="273317"/>
                </a:cubicBezTo>
                <a:cubicBezTo>
                  <a:pt x="852382" y="268455"/>
                  <a:pt x="842556" y="267340"/>
                  <a:pt x="833591" y="264352"/>
                </a:cubicBezTo>
                <a:cubicBezTo>
                  <a:pt x="797732" y="267340"/>
                  <a:pt x="761199" y="265778"/>
                  <a:pt x="726015" y="273317"/>
                </a:cubicBezTo>
                <a:cubicBezTo>
                  <a:pt x="684355" y="282244"/>
                  <a:pt x="724418" y="360090"/>
                  <a:pt x="726015" y="362964"/>
                </a:cubicBezTo>
                <a:cubicBezTo>
                  <a:pt x="730604" y="371224"/>
                  <a:pt x="743944" y="368941"/>
                  <a:pt x="752909" y="371929"/>
                </a:cubicBezTo>
                <a:cubicBezTo>
                  <a:pt x="758885" y="380894"/>
                  <a:pt x="762425" y="392093"/>
                  <a:pt x="770838" y="398823"/>
                </a:cubicBezTo>
                <a:cubicBezTo>
                  <a:pt x="778217" y="404726"/>
                  <a:pt x="788884" y="404469"/>
                  <a:pt x="797732" y="407787"/>
                </a:cubicBezTo>
                <a:cubicBezTo>
                  <a:pt x="812800" y="413437"/>
                  <a:pt x="827973" y="418912"/>
                  <a:pt x="842556" y="425717"/>
                </a:cubicBezTo>
                <a:cubicBezTo>
                  <a:pt x="872831" y="439845"/>
                  <a:pt x="902321" y="455599"/>
                  <a:pt x="932203" y="470540"/>
                </a:cubicBezTo>
                <a:cubicBezTo>
                  <a:pt x="984067" y="496472"/>
                  <a:pt x="1002987" y="492672"/>
                  <a:pt x="1048744" y="506399"/>
                </a:cubicBezTo>
                <a:cubicBezTo>
                  <a:pt x="1066846" y="511830"/>
                  <a:pt x="1084603" y="518352"/>
                  <a:pt x="1102532" y="524329"/>
                </a:cubicBezTo>
                <a:cubicBezTo>
                  <a:pt x="1112753" y="527736"/>
                  <a:pt x="1119789" y="537440"/>
                  <a:pt x="1129426" y="542258"/>
                </a:cubicBezTo>
                <a:cubicBezTo>
                  <a:pt x="1143819" y="549455"/>
                  <a:pt x="1160051" y="552614"/>
                  <a:pt x="1174250" y="560187"/>
                </a:cubicBezTo>
                <a:cubicBezTo>
                  <a:pt x="1204999" y="576586"/>
                  <a:pt x="1263897" y="613976"/>
                  <a:pt x="1263897" y="613976"/>
                </a:cubicBezTo>
                <a:cubicBezTo>
                  <a:pt x="1308411" y="680748"/>
                  <a:pt x="1251200" y="598739"/>
                  <a:pt x="1308721" y="667764"/>
                </a:cubicBezTo>
                <a:cubicBezTo>
                  <a:pt x="1315618" y="676041"/>
                  <a:pt x="1320674" y="685693"/>
                  <a:pt x="1326650" y="694658"/>
                </a:cubicBezTo>
                <a:cubicBezTo>
                  <a:pt x="1323662" y="712587"/>
                  <a:pt x="1327319" y="733032"/>
                  <a:pt x="1317685" y="748446"/>
                </a:cubicBezTo>
                <a:cubicBezTo>
                  <a:pt x="1310602" y="759779"/>
                  <a:pt x="1294987" y="764054"/>
                  <a:pt x="1281826" y="766376"/>
                </a:cubicBezTo>
                <a:cubicBezTo>
                  <a:pt x="1243457" y="773147"/>
                  <a:pt x="1204132" y="772352"/>
                  <a:pt x="1165285" y="775340"/>
                </a:cubicBezTo>
                <a:cubicBezTo>
                  <a:pt x="1135403" y="772352"/>
                  <a:pt x="1103359" y="777926"/>
                  <a:pt x="1075638" y="766376"/>
                </a:cubicBezTo>
                <a:cubicBezTo>
                  <a:pt x="1063302" y="761236"/>
                  <a:pt x="1062276" y="743076"/>
                  <a:pt x="1057709" y="730517"/>
                </a:cubicBezTo>
                <a:cubicBezTo>
                  <a:pt x="1050274" y="710072"/>
                  <a:pt x="1046177" y="688557"/>
                  <a:pt x="1039779" y="667764"/>
                </a:cubicBezTo>
                <a:cubicBezTo>
                  <a:pt x="1034221" y="649701"/>
                  <a:pt x="1027826" y="631905"/>
                  <a:pt x="1021850" y="613976"/>
                </a:cubicBezTo>
                <a:cubicBezTo>
                  <a:pt x="1027826" y="578117"/>
                  <a:pt x="1021743" y="537963"/>
                  <a:pt x="1039779" y="506399"/>
                </a:cubicBezTo>
                <a:cubicBezTo>
                  <a:pt x="1049156" y="489990"/>
                  <a:pt x="1076363" y="496291"/>
                  <a:pt x="1093568" y="488470"/>
                </a:cubicBezTo>
                <a:cubicBezTo>
                  <a:pt x="1109430" y="481260"/>
                  <a:pt x="1122571" y="468878"/>
                  <a:pt x="1138391" y="461576"/>
                </a:cubicBezTo>
                <a:cubicBezTo>
                  <a:pt x="1161573" y="450877"/>
                  <a:pt x="1186203" y="443647"/>
                  <a:pt x="1210109" y="434682"/>
                </a:cubicBezTo>
                <a:cubicBezTo>
                  <a:pt x="1222062" y="422729"/>
                  <a:pt x="1239467" y="414427"/>
                  <a:pt x="1245968" y="398823"/>
                </a:cubicBezTo>
                <a:cubicBezTo>
                  <a:pt x="1276872" y="324651"/>
                  <a:pt x="1223930" y="316771"/>
                  <a:pt x="1281826" y="336070"/>
                </a:cubicBezTo>
                <a:cubicBezTo>
                  <a:pt x="1300053" y="427202"/>
                  <a:pt x="1281378" y="343465"/>
                  <a:pt x="1299756" y="407787"/>
                </a:cubicBezTo>
                <a:cubicBezTo>
                  <a:pt x="1322277" y="486609"/>
                  <a:pt x="1296186" y="406038"/>
                  <a:pt x="1317685" y="470540"/>
                </a:cubicBezTo>
                <a:cubicBezTo>
                  <a:pt x="1311709" y="506399"/>
                  <a:pt x="1311252" y="543629"/>
                  <a:pt x="1299756" y="578117"/>
                </a:cubicBezTo>
                <a:cubicBezTo>
                  <a:pt x="1295747" y="590144"/>
                  <a:pt x="1279581" y="594260"/>
                  <a:pt x="1272862" y="605011"/>
                </a:cubicBezTo>
                <a:cubicBezTo>
                  <a:pt x="1216267" y="695563"/>
                  <a:pt x="1293063" y="611704"/>
                  <a:pt x="1228038" y="676729"/>
                </a:cubicBezTo>
                <a:cubicBezTo>
                  <a:pt x="1212283" y="723993"/>
                  <a:pt x="1229486" y="685748"/>
                  <a:pt x="1192179" y="730517"/>
                </a:cubicBezTo>
                <a:cubicBezTo>
                  <a:pt x="1185282" y="738794"/>
                  <a:pt x="1181868" y="749793"/>
                  <a:pt x="1174250" y="757411"/>
                </a:cubicBezTo>
                <a:cubicBezTo>
                  <a:pt x="1156873" y="774788"/>
                  <a:pt x="1142334" y="777014"/>
                  <a:pt x="1120462" y="784305"/>
                </a:cubicBezTo>
                <a:cubicBezTo>
                  <a:pt x="1087591" y="781317"/>
                  <a:pt x="1053397" y="785047"/>
                  <a:pt x="1021850" y="775340"/>
                </a:cubicBezTo>
                <a:cubicBezTo>
                  <a:pt x="1011552" y="772171"/>
                  <a:pt x="1008991" y="757953"/>
                  <a:pt x="1003921" y="748446"/>
                </a:cubicBezTo>
                <a:cubicBezTo>
                  <a:pt x="985054" y="713071"/>
                  <a:pt x="950132" y="640870"/>
                  <a:pt x="950132" y="640870"/>
                </a:cubicBezTo>
                <a:cubicBezTo>
                  <a:pt x="956109" y="590070"/>
                  <a:pt x="954010" y="537652"/>
                  <a:pt x="968062" y="488470"/>
                </a:cubicBezTo>
                <a:cubicBezTo>
                  <a:pt x="972706" y="472216"/>
                  <a:pt x="991086" y="463612"/>
                  <a:pt x="1003921" y="452611"/>
                </a:cubicBezTo>
                <a:cubicBezTo>
                  <a:pt x="1026038" y="433654"/>
                  <a:pt x="1031680" y="434394"/>
                  <a:pt x="1057709" y="425717"/>
                </a:cubicBezTo>
                <a:cubicBezTo>
                  <a:pt x="1054721" y="401811"/>
                  <a:pt x="1058713" y="375932"/>
                  <a:pt x="1048744" y="353999"/>
                </a:cubicBezTo>
                <a:cubicBezTo>
                  <a:pt x="1041226" y="337459"/>
                  <a:pt x="991338" y="317354"/>
                  <a:pt x="977026" y="309176"/>
                </a:cubicBezTo>
                <a:cubicBezTo>
                  <a:pt x="967671" y="303830"/>
                  <a:pt x="960353" y="294653"/>
                  <a:pt x="950132" y="291246"/>
                </a:cubicBezTo>
                <a:cubicBezTo>
                  <a:pt x="932888" y="285498"/>
                  <a:pt x="914471" y="283625"/>
                  <a:pt x="896344" y="282282"/>
                </a:cubicBezTo>
                <a:cubicBezTo>
                  <a:pt x="833692" y="277641"/>
                  <a:pt x="770794" y="277118"/>
                  <a:pt x="708085" y="273317"/>
                </a:cubicBezTo>
                <a:cubicBezTo>
                  <a:pt x="672168" y="271140"/>
                  <a:pt x="636368" y="267340"/>
                  <a:pt x="600509" y="264352"/>
                </a:cubicBezTo>
                <a:cubicBezTo>
                  <a:pt x="574563" y="255704"/>
                  <a:pt x="435271" y="197502"/>
                  <a:pt x="412250" y="246423"/>
                </a:cubicBezTo>
                <a:cubicBezTo>
                  <a:pt x="387583" y="298841"/>
                  <a:pt x="445647" y="385754"/>
                  <a:pt x="475003" y="434682"/>
                </a:cubicBezTo>
                <a:cubicBezTo>
                  <a:pt x="487019" y="482745"/>
                  <a:pt x="481404" y="471304"/>
                  <a:pt x="510862" y="524329"/>
                </a:cubicBezTo>
                <a:cubicBezTo>
                  <a:pt x="516094" y="533747"/>
                  <a:pt x="523973" y="541586"/>
                  <a:pt x="528791" y="551223"/>
                </a:cubicBezTo>
                <a:cubicBezTo>
                  <a:pt x="535988" y="565616"/>
                  <a:pt x="538192" y="582400"/>
                  <a:pt x="546721" y="596046"/>
                </a:cubicBezTo>
                <a:cubicBezTo>
                  <a:pt x="579201" y="648013"/>
                  <a:pt x="568310" y="597558"/>
                  <a:pt x="591544" y="649835"/>
                </a:cubicBezTo>
                <a:cubicBezTo>
                  <a:pt x="599219" y="667105"/>
                  <a:pt x="601021" y="686719"/>
                  <a:pt x="609473" y="703623"/>
                </a:cubicBezTo>
                <a:lnTo>
                  <a:pt x="627403" y="739482"/>
                </a:lnTo>
                <a:cubicBezTo>
                  <a:pt x="624421" y="760359"/>
                  <a:pt x="625392" y="825400"/>
                  <a:pt x="591544" y="838093"/>
                </a:cubicBezTo>
                <a:cubicBezTo>
                  <a:pt x="577277" y="843443"/>
                  <a:pt x="561662" y="832117"/>
                  <a:pt x="546721" y="829129"/>
                </a:cubicBezTo>
                <a:cubicBezTo>
                  <a:pt x="491880" y="774288"/>
                  <a:pt x="579770" y="858398"/>
                  <a:pt x="492932" y="793270"/>
                </a:cubicBezTo>
                <a:cubicBezTo>
                  <a:pt x="479409" y="783128"/>
                  <a:pt x="457073" y="757411"/>
                  <a:pt x="457073" y="757411"/>
                </a:cubicBezTo>
                <a:cubicBezTo>
                  <a:pt x="448108" y="739482"/>
                  <a:pt x="439914" y="721146"/>
                  <a:pt x="430179" y="703623"/>
                </a:cubicBezTo>
                <a:cubicBezTo>
                  <a:pt x="424947" y="694205"/>
                  <a:pt x="417482" y="686147"/>
                  <a:pt x="412250" y="676729"/>
                </a:cubicBezTo>
                <a:cubicBezTo>
                  <a:pt x="359402" y="581601"/>
                  <a:pt x="407836" y="656658"/>
                  <a:pt x="367426" y="596046"/>
                </a:cubicBezTo>
                <a:cubicBezTo>
                  <a:pt x="356765" y="542735"/>
                  <a:pt x="346739" y="514674"/>
                  <a:pt x="367426" y="452611"/>
                </a:cubicBezTo>
                <a:cubicBezTo>
                  <a:pt x="372771" y="436574"/>
                  <a:pt x="389220" y="426129"/>
                  <a:pt x="403285" y="416752"/>
                </a:cubicBezTo>
                <a:lnTo>
                  <a:pt x="457073" y="380893"/>
                </a:lnTo>
                <a:cubicBezTo>
                  <a:pt x="492932" y="383881"/>
                  <a:pt x="530763" y="377755"/>
                  <a:pt x="564650" y="389858"/>
                </a:cubicBezTo>
                <a:cubicBezTo>
                  <a:pt x="577235" y="394353"/>
                  <a:pt x="573882" y="415570"/>
                  <a:pt x="582579" y="425717"/>
                </a:cubicBezTo>
                <a:cubicBezTo>
                  <a:pt x="592303" y="437061"/>
                  <a:pt x="607873" y="442046"/>
                  <a:pt x="618438" y="452611"/>
                </a:cubicBezTo>
                <a:cubicBezTo>
                  <a:pt x="629003" y="463176"/>
                  <a:pt x="635608" y="477126"/>
                  <a:pt x="645332" y="488470"/>
                </a:cubicBezTo>
                <a:cubicBezTo>
                  <a:pt x="653583" y="498096"/>
                  <a:pt x="664769" y="505111"/>
                  <a:pt x="672226" y="515364"/>
                </a:cubicBezTo>
                <a:cubicBezTo>
                  <a:pt x="688807" y="538163"/>
                  <a:pt x="701915" y="563298"/>
                  <a:pt x="717050" y="587082"/>
                </a:cubicBezTo>
                <a:cubicBezTo>
                  <a:pt x="722834" y="596172"/>
                  <a:pt x="734979" y="613976"/>
                  <a:pt x="734979" y="613976"/>
                </a:cubicBezTo>
                <a:cubicBezTo>
                  <a:pt x="731991" y="646846"/>
                  <a:pt x="735721" y="681041"/>
                  <a:pt x="726015" y="712587"/>
                </a:cubicBezTo>
                <a:cubicBezTo>
                  <a:pt x="722846" y="722885"/>
                  <a:pt x="707534" y="723786"/>
                  <a:pt x="699121" y="730517"/>
                </a:cubicBezTo>
                <a:cubicBezTo>
                  <a:pt x="692521" y="735797"/>
                  <a:pt x="688751" y="744666"/>
                  <a:pt x="681191" y="748446"/>
                </a:cubicBezTo>
                <a:cubicBezTo>
                  <a:pt x="664287" y="756898"/>
                  <a:pt x="627403" y="766376"/>
                  <a:pt x="627403" y="766376"/>
                </a:cubicBezTo>
                <a:cubicBezTo>
                  <a:pt x="622925" y="761898"/>
                  <a:pt x="587303" y="728620"/>
                  <a:pt x="591544" y="721552"/>
                </a:cubicBezTo>
                <a:cubicBezTo>
                  <a:pt x="599824" y="707753"/>
                  <a:pt x="621427" y="709599"/>
                  <a:pt x="636368" y="703623"/>
                </a:cubicBezTo>
                <a:cubicBezTo>
                  <a:pt x="843643" y="772715"/>
                  <a:pt x="765462" y="736795"/>
                  <a:pt x="878415" y="793270"/>
                </a:cubicBezTo>
                <a:cubicBezTo>
                  <a:pt x="890368" y="805223"/>
                  <a:pt x="903272" y="816295"/>
                  <a:pt x="914273" y="829129"/>
                </a:cubicBezTo>
                <a:cubicBezTo>
                  <a:pt x="921285" y="837309"/>
                  <a:pt x="924584" y="848404"/>
                  <a:pt x="932203" y="856023"/>
                </a:cubicBezTo>
                <a:cubicBezTo>
                  <a:pt x="978803" y="902621"/>
                  <a:pt x="941537" y="847521"/>
                  <a:pt x="977026" y="891882"/>
                </a:cubicBezTo>
                <a:cubicBezTo>
                  <a:pt x="983757" y="900295"/>
                  <a:pt x="987337" y="911157"/>
                  <a:pt x="994956" y="918776"/>
                </a:cubicBezTo>
                <a:cubicBezTo>
                  <a:pt x="1012334" y="936154"/>
                  <a:pt x="1026871" y="938379"/>
                  <a:pt x="1048744" y="945670"/>
                </a:cubicBezTo>
                <a:cubicBezTo>
                  <a:pt x="1063685" y="942682"/>
                  <a:pt x="1090142" y="951552"/>
                  <a:pt x="1093568" y="936705"/>
                </a:cubicBezTo>
                <a:cubicBezTo>
                  <a:pt x="1108308" y="872831"/>
                  <a:pt x="1072063" y="826643"/>
                  <a:pt x="1048744" y="775340"/>
                </a:cubicBezTo>
                <a:cubicBezTo>
                  <a:pt x="993331" y="653429"/>
                  <a:pt x="1068016" y="793355"/>
                  <a:pt x="1003921" y="703623"/>
                </a:cubicBezTo>
                <a:cubicBezTo>
                  <a:pt x="996153" y="692748"/>
                  <a:pt x="995441" y="677214"/>
                  <a:pt x="985991" y="667764"/>
                </a:cubicBezTo>
                <a:cubicBezTo>
                  <a:pt x="976541" y="658314"/>
                  <a:pt x="961735" y="656465"/>
                  <a:pt x="950132" y="649835"/>
                </a:cubicBezTo>
                <a:cubicBezTo>
                  <a:pt x="940777" y="644489"/>
                  <a:pt x="933773" y="634163"/>
                  <a:pt x="923238" y="631905"/>
                </a:cubicBezTo>
                <a:cubicBezTo>
                  <a:pt x="890964" y="624989"/>
                  <a:pt x="857497" y="625928"/>
                  <a:pt x="824626" y="622940"/>
                </a:cubicBezTo>
                <a:cubicBezTo>
                  <a:pt x="620512" y="641497"/>
                  <a:pt x="603113" y="578556"/>
                  <a:pt x="645332" y="694658"/>
                </a:cubicBezTo>
                <a:cubicBezTo>
                  <a:pt x="650831" y="709781"/>
                  <a:pt x="657285" y="724541"/>
                  <a:pt x="663262" y="739482"/>
                </a:cubicBezTo>
                <a:cubicBezTo>
                  <a:pt x="670537" y="797689"/>
                  <a:pt x="668028" y="800989"/>
                  <a:pt x="681191" y="847058"/>
                </a:cubicBezTo>
                <a:cubicBezTo>
                  <a:pt x="683787" y="856144"/>
                  <a:pt x="685468" y="865747"/>
                  <a:pt x="690156" y="873952"/>
                </a:cubicBezTo>
                <a:cubicBezTo>
                  <a:pt x="697569" y="886925"/>
                  <a:pt x="708482" y="897571"/>
                  <a:pt x="717050" y="909811"/>
                </a:cubicBezTo>
                <a:cubicBezTo>
                  <a:pt x="729407" y="927464"/>
                  <a:pt x="740956" y="945670"/>
                  <a:pt x="752909" y="963599"/>
                </a:cubicBezTo>
                <a:cubicBezTo>
                  <a:pt x="757597" y="970632"/>
                  <a:pt x="763069" y="978200"/>
                  <a:pt x="770838" y="981529"/>
                </a:cubicBezTo>
                <a:cubicBezTo>
                  <a:pt x="784843" y="987531"/>
                  <a:pt x="800788" y="987188"/>
                  <a:pt x="815662" y="990493"/>
                </a:cubicBezTo>
                <a:cubicBezTo>
                  <a:pt x="891758" y="1007403"/>
                  <a:pt x="805473" y="992879"/>
                  <a:pt x="914273" y="1008423"/>
                </a:cubicBezTo>
                <a:cubicBezTo>
                  <a:pt x="929214" y="1005435"/>
                  <a:pt x="946698" y="1008315"/>
                  <a:pt x="959097" y="999458"/>
                </a:cubicBezTo>
                <a:cubicBezTo>
                  <a:pt x="969972" y="991690"/>
                  <a:pt x="977026" y="976963"/>
                  <a:pt x="977026" y="963599"/>
                </a:cubicBezTo>
                <a:cubicBezTo>
                  <a:pt x="977026" y="896558"/>
                  <a:pt x="972362" y="846053"/>
                  <a:pt x="914273" y="811199"/>
                </a:cubicBezTo>
                <a:cubicBezTo>
                  <a:pt x="899332" y="802234"/>
                  <a:pt x="885534" y="791007"/>
                  <a:pt x="869450" y="784305"/>
                </a:cubicBezTo>
                <a:cubicBezTo>
                  <a:pt x="796441" y="753885"/>
                  <a:pt x="725546" y="761867"/>
                  <a:pt x="645332" y="757411"/>
                </a:cubicBezTo>
                <a:cubicBezTo>
                  <a:pt x="597098" y="746693"/>
                  <a:pt x="480400" y="712691"/>
                  <a:pt x="439144" y="748446"/>
                </a:cubicBezTo>
                <a:cubicBezTo>
                  <a:pt x="411952" y="772013"/>
                  <a:pt x="439810" y="821352"/>
                  <a:pt x="430179" y="856023"/>
                </a:cubicBezTo>
                <a:cubicBezTo>
                  <a:pt x="424412" y="876785"/>
                  <a:pt x="406274" y="891882"/>
                  <a:pt x="394321" y="909811"/>
                </a:cubicBezTo>
                <a:cubicBezTo>
                  <a:pt x="397309" y="945670"/>
                  <a:pt x="395044" y="982361"/>
                  <a:pt x="403285" y="1017387"/>
                </a:cubicBezTo>
                <a:cubicBezTo>
                  <a:pt x="407864" y="1036848"/>
                  <a:pt x="430791" y="1065709"/>
                  <a:pt x="448109" y="1080140"/>
                </a:cubicBezTo>
                <a:cubicBezTo>
                  <a:pt x="459587" y="1089705"/>
                  <a:pt x="470604" y="1100353"/>
                  <a:pt x="483968" y="1107035"/>
                </a:cubicBezTo>
                <a:cubicBezTo>
                  <a:pt x="494988" y="1112545"/>
                  <a:pt x="507873" y="1113011"/>
                  <a:pt x="519826" y="1115999"/>
                </a:cubicBezTo>
                <a:cubicBezTo>
                  <a:pt x="531779" y="1101058"/>
                  <a:pt x="544204" y="1086483"/>
                  <a:pt x="555685" y="1071176"/>
                </a:cubicBezTo>
                <a:cubicBezTo>
                  <a:pt x="562150" y="1062557"/>
                  <a:pt x="564260" y="1049628"/>
                  <a:pt x="573615" y="1044282"/>
                </a:cubicBezTo>
                <a:cubicBezTo>
                  <a:pt x="586844" y="1036722"/>
                  <a:pt x="603844" y="1039695"/>
                  <a:pt x="618438" y="1035317"/>
                </a:cubicBezTo>
                <a:cubicBezTo>
                  <a:pt x="633852" y="1030693"/>
                  <a:pt x="647995" y="1022476"/>
                  <a:pt x="663262" y="1017387"/>
                </a:cubicBezTo>
                <a:cubicBezTo>
                  <a:pt x="674951" y="1013491"/>
                  <a:pt x="687168" y="1011411"/>
                  <a:pt x="699121" y="1008423"/>
                </a:cubicBezTo>
                <a:cubicBezTo>
                  <a:pt x="722898" y="996534"/>
                  <a:pt x="752737" y="984286"/>
                  <a:pt x="770838" y="963599"/>
                </a:cubicBezTo>
                <a:cubicBezTo>
                  <a:pt x="782312" y="950486"/>
                  <a:pt x="783921" y="929400"/>
                  <a:pt x="797732" y="918776"/>
                </a:cubicBezTo>
                <a:cubicBezTo>
                  <a:pt x="832417" y="892095"/>
                  <a:pt x="896338" y="869472"/>
                  <a:pt x="941168" y="856023"/>
                </a:cubicBezTo>
                <a:cubicBezTo>
                  <a:pt x="952969" y="852483"/>
                  <a:pt x="965073" y="850046"/>
                  <a:pt x="977026" y="847058"/>
                </a:cubicBezTo>
                <a:cubicBezTo>
                  <a:pt x="1042767" y="850046"/>
                  <a:pt x="1109466" y="844454"/>
                  <a:pt x="1174250" y="856023"/>
                </a:cubicBezTo>
                <a:cubicBezTo>
                  <a:pt x="1195463" y="859811"/>
                  <a:pt x="1210109" y="879929"/>
                  <a:pt x="1228038" y="891882"/>
                </a:cubicBezTo>
                <a:cubicBezTo>
                  <a:pt x="1266049" y="917222"/>
                  <a:pt x="1245299" y="904995"/>
                  <a:pt x="1290791" y="927740"/>
                </a:cubicBezTo>
                <a:cubicBezTo>
                  <a:pt x="1296768" y="921764"/>
                  <a:pt x="1307673" y="918198"/>
                  <a:pt x="1308721" y="909811"/>
                </a:cubicBezTo>
                <a:cubicBezTo>
                  <a:pt x="1313542" y="871248"/>
                  <a:pt x="1284972" y="825563"/>
                  <a:pt x="1272862" y="793270"/>
                </a:cubicBezTo>
                <a:cubicBezTo>
                  <a:pt x="1243485" y="714930"/>
                  <a:pt x="1248536" y="727992"/>
                  <a:pt x="1237003" y="658799"/>
                </a:cubicBezTo>
                <a:cubicBezTo>
                  <a:pt x="1239991" y="628917"/>
                  <a:pt x="1232538" y="596013"/>
                  <a:pt x="1245968" y="569152"/>
                </a:cubicBezTo>
                <a:cubicBezTo>
                  <a:pt x="1252520" y="556048"/>
                  <a:pt x="1324646" y="544452"/>
                  <a:pt x="1335615" y="542258"/>
                </a:cubicBezTo>
                <a:lnTo>
                  <a:pt x="1649379" y="551223"/>
                </a:lnTo>
                <a:cubicBezTo>
                  <a:pt x="1664141" y="553530"/>
                  <a:pt x="1628668" y="573480"/>
                  <a:pt x="1622485" y="587082"/>
                </a:cubicBezTo>
                <a:cubicBezTo>
                  <a:pt x="1613483" y="606887"/>
                  <a:pt x="1613391" y="629955"/>
                  <a:pt x="1604556" y="649835"/>
                </a:cubicBezTo>
                <a:cubicBezTo>
                  <a:pt x="1601123" y="657559"/>
                  <a:pt x="1591906" y="661164"/>
                  <a:pt x="1586626" y="667764"/>
                </a:cubicBezTo>
                <a:cubicBezTo>
                  <a:pt x="1545891" y="718681"/>
                  <a:pt x="1597426" y="673834"/>
                  <a:pt x="1532838" y="712587"/>
                </a:cubicBezTo>
                <a:cubicBezTo>
                  <a:pt x="1514360" y="723674"/>
                  <a:pt x="1497528" y="737359"/>
                  <a:pt x="1479050" y="748446"/>
                </a:cubicBezTo>
                <a:cubicBezTo>
                  <a:pt x="1467591" y="755322"/>
                  <a:pt x="1454524" y="759293"/>
                  <a:pt x="1443191" y="766376"/>
                </a:cubicBezTo>
                <a:cubicBezTo>
                  <a:pt x="1430521" y="774295"/>
                  <a:pt x="1419572" y="784702"/>
                  <a:pt x="1407332" y="793270"/>
                </a:cubicBezTo>
                <a:cubicBezTo>
                  <a:pt x="1314389" y="858330"/>
                  <a:pt x="1391002" y="799163"/>
                  <a:pt x="1308721" y="864987"/>
                </a:cubicBezTo>
                <a:cubicBezTo>
                  <a:pt x="1305733" y="873952"/>
                  <a:pt x="1303479" y="883196"/>
                  <a:pt x="1299756" y="891882"/>
                </a:cubicBezTo>
                <a:cubicBezTo>
                  <a:pt x="1294492" y="904165"/>
                  <a:pt x="1281826" y="914376"/>
                  <a:pt x="1281826" y="927740"/>
                </a:cubicBezTo>
                <a:cubicBezTo>
                  <a:pt x="1281826" y="1031902"/>
                  <a:pt x="1389657" y="990992"/>
                  <a:pt x="1470085" y="999458"/>
                </a:cubicBezTo>
                <a:lnTo>
                  <a:pt x="1586626" y="981529"/>
                </a:lnTo>
                <a:cubicBezTo>
                  <a:pt x="1613199" y="941669"/>
                  <a:pt x="1583858" y="885596"/>
                  <a:pt x="1577662" y="838093"/>
                </a:cubicBezTo>
                <a:cubicBezTo>
                  <a:pt x="1575207" y="819268"/>
                  <a:pt x="1557700" y="759921"/>
                  <a:pt x="1541803" y="739482"/>
                </a:cubicBezTo>
                <a:cubicBezTo>
                  <a:pt x="1528830" y="722803"/>
                  <a:pt x="1510179" y="711158"/>
                  <a:pt x="1496979" y="694658"/>
                </a:cubicBezTo>
                <a:cubicBezTo>
                  <a:pt x="1486094" y="681052"/>
                  <a:pt x="1480212" y="664014"/>
                  <a:pt x="1470085" y="649835"/>
                </a:cubicBezTo>
                <a:cubicBezTo>
                  <a:pt x="1465172" y="642957"/>
                  <a:pt x="1457657" y="638322"/>
                  <a:pt x="1452156" y="631905"/>
                </a:cubicBezTo>
                <a:cubicBezTo>
                  <a:pt x="1402470" y="573938"/>
                  <a:pt x="1436213" y="600360"/>
                  <a:pt x="1389403" y="569152"/>
                </a:cubicBezTo>
                <a:cubicBezTo>
                  <a:pt x="1357153" y="504654"/>
                  <a:pt x="1365591" y="537066"/>
                  <a:pt x="1380438" y="425717"/>
                </a:cubicBezTo>
                <a:cubicBezTo>
                  <a:pt x="1381687" y="416350"/>
                  <a:pt x="1382721" y="405505"/>
                  <a:pt x="1389403" y="398823"/>
                </a:cubicBezTo>
                <a:cubicBezTo>
                  <a:pt x="1396085" y="392141"/>
                  <a:pt x="1407332" y="392846"/>
                  <a:pt x="1416297" y="389858"/>
                </a:cubicBezTo>
                <a:cubicBezTo>
                  <a:pt x="1413309" y="374917"/>
                  <a:pt x="1422382" y="347411"/>
                  <a:pt x="1407332" y="345035"/>
                </a:cubicBezTo>
                <a:cubicBezTo>
                  <a:pt x="1353875" y="336594"/>
                  <a:pt x="1299591" y="355652"/>
                  <a:pt x="1245968" y="362964"/>
                </a:cubicBezTo>
                <a:cubicBezTo>
                  <a:pt x="1233760" y="364629"/>
                  <a:pt x="1221996" y="368687"/>
                  <a:pt x="1210109" y="371929"/>
                </a:cubicBezTo>
                <a:cubicBezTo>
                  <a:pt x="1182318" y="379508"/>
                  <a:pt x="1121835" y="396480"/>
                  <a:pt x="1093568" y="407787"/>
                </a:cubicBezTo>
                <a:cubicBezTo>
                  <a:pt x="1081160" y="412750"/>
                  <a:pt x="1069662" y="419740"/>
                  <a:pt x="1057709" y="425717"/>
                </a:cubicBezTo>
                <a:cubicBezTo>
                  <a:pt x="1045757" y="443644"/>
                  <a:pt x="1024837" y="489965"/>
                  <a:pt x="994956" y="497435"/>
                </a:cubicBezTo>
                <a:cubicBezTo>
                  <a:pt x="956826" y="506968"/>
                  <a:pt x="917262" y="509388"/>
                  <a:pt x="878415" y="515364"/>
                </a:cubicBezTo>
                <a:cubicBezTo>
                  <a:pt x="758885" y="509388"/>
                  <a:pt x="638966" y="508782"/>
                  <a:pt x="519826" y="497435"/>
                </a:cubicBezTo>
                <a:cubicBezTo>
                  <a:pt x="511412" y="496634"/>
                  <a:pt x="507308" y="485998"/>
                  <a:pt x="501897" y="479505"/>
                </a:cubicBezTo>
                <a:cubicBezTo>
                  <a:pt x="492332" y="468027"/>
                  <a:pt x="484568" y="455124"/>
                  <a:pt x="475003" y="443646"/>
                </a:cubicBezTo>
                <a:cubicBezTo>
                  <a:pt x="469592" y="437153"/>
                  <a:pt x="461986" y="432595"/>
                  <a:pt x="457073" y="425717"/>
                </a:cubicBezTo>
                <a:cubicBezTo>
                  <a:pt x="446945" y="411538"/>
                  <a:pt x="437971" y="396478"/>
                  <a:pt x="430179" y="380893"/>
                </a:cubicBezTo>
                <a:cubicBezTo>
                  <a:pt x="425361" y="371256"/>
                  <a:pt x="442132" y="398822"/>
                  <a:pt x="448109" y="407787"/>
                </a:cubicBezTo>
                <a:cubicBezTo>
                  <a:pt x="445121" y="431693"/>
                  <a:pt x="449113" y="457572"/>
                  <a:pt x="439144" y="479505"/>
                </a:cubicBezTo>
                <a:cubicBezTo>
                  <a:pt x="424685" y="511314"/>
                  <a:pt x="374298" y="511230"/>
                  <a:pt x="349497" y="515364"/>
                </a:cubicBezTo>
                <a:cubicBezTo>
                  <a:pt x="331519" y="513019"/>
                  <a:pt x="145122" y="511617"/>
                  <a:pt x="89521" y="461576"/>
                </a:cubicBezTo>
                <a:cubicBezTo>
                  <a:pt x="73504" y="447161"/>
                  <a:pt x="68900" y="423024"/>
                  <a:pt x="53662" y="407787"/>
                </a:cubicBezTo>
                <a:lnTo>
                  <a:pt x="35732" y="389858"/>
                </a:lnTo>
                <a:cubicBezTo>
                  <a:pt x="17881" y="354155"/>
                  <a:pt x="8838" y="344856"/>
                  <a:pt x="8838" y="300211"/>
                </a:cubicBezTo>
                <a:cubicBezTo>
                  <a:pt x="8838" y="282034"/>
                  <a:pt x="0" y="250088"/>
                  <a:pt x="17803" y="246423"/>
                </a:cubicBezTo>
                <a:cubicBezTo>
                  <a:pt x="114433" y="226529"/>
                  <a:pt x="215026" y="240446"/>
                  <a:pt x="313638" y="237458"/>
                </a:cubicBezTo>
                <a:cubicBezTo>
                  <a:pt x="316626" y="225505"/>
                  <a:pt x="311583" y="207109"/>
                  <a:pt x="322603" y="201599"/>
                </a:cubicBezTo>
                <a:cubicBezTo>
                  <a:pt x="336231" y="194785"/>
                  <a:pt x="352644" y="206868"/>
                  <a:pt x="367426" y="210564"/>
                </a:cubicBezTo>
                <a:cubicBezTo>
                  <a:pt x="370325" y="211289"/>
                  <a:pt x="361450" y="210564"/>
                  <a:pt x="322603" y="237458"/>
                </a:cubicBezTo>
                <a:close/>
              </a:path>
            </a:pathLst>
          </a:custGeom>
          <a:noFill/>
          <a:ln w="31680">
            <a:solidFill>
              <a:srgbClr val="a6a6a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229"/>
          <p:cNvSpPr/>
          <p:nvPr/>
        </p:nvSpPr>
        <p:spPr>
          <a:xfrm rot="10800000">
            <a:off x="4348080" y="1866960"/>
            <a:ext cx="28800" cy="233280"/>
          </a:xfrm>
          <a:custGeom>
            <a:avLst/>
            <a:gdLst>
              <a:gd name="textAreaLeft" fmla="*/ 0 w 28800"/>
              <a:gd name="textAreaRight" fmla="*/ 29160 w 2880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1" h="147">
                <a:moveTo>
                  <a:pt x="8" y="147"/>
                </a:moveTo>
                <a:lnTo>
                  <a:pt x="31" y="73"/>
                </a:lnTo>
                <a:lnTo>
                  <a:pt x="8" y="0"/>
                </a:lnTo>
                <a:lnTo>
                  <a:pt x="8" y="33"/>
                </a:lnTo>
                <a:lnTo>
                  <a:pt x="0" y="33"/>
                </a:lnTo>
                <a:lnTo>
                  <a:pt x="0" y="114"/>
                </a:lnTo>
                <a:lnTo>
                  <a:pt x="8" y="114"/>
                </a:lnTo>
                <a:lnTo>
                  <a:pt x="8" y="147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0d0d0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31"/>
          <p:cNvSpPr/>
          <p:nvPr/>
        </p:nvSpPr>
        <p:spPr>
          <a:xfrm>
            <a:off x="4255920" y="1719360"/>
            <a:ext cx="198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t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字方塊 362"/>
          <p:cNvSpPr/>
          <p:nvPr/>
        </p:nvSpPr>
        <p:spPr>
          <a:xfrm>
            <a:off x="4202640" y="1262160"/>
            <a:ext cx="27972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×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字方塊 387"/>
          <p:cNvSpPr/>
          <p:nvPr/>
        </p:nvSpPr>
        <p:spPr>
          <a:xfrm>
            <a:off x="1074600" y="3065400"/>
            <a:ext cx="64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群組 167"/>
          <p:cNvGrpSpPr/>
          <p:nvPr/>
        </p:nvGrpSpPr>
        <p:grpSpPr>
          <a:xfrm>
            <a:off x="6872040" y="1068480"/>
            <a:ext cx="135000" cy="142920"/>
            <a:chOff x="6872040" y="1068480"/>
            <a:chExt cx="135000" cy="142920"/>
          </a:xfrm>
        </p:grpSpPr>
        <p:sp>
          <p:nvSpPr>
            <p:cNvPr id="61" name="直線接點 165"/>
            <p:cNvSpPr/>
            <p:nvPr/>
          </p:nvSpPr>
          <p:spPr>
            <a:xfrm flipH="1">
              <a:off x="6872040" y="1068480"/>
              <a:ext cx="71640" cy="1429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線接點 166"/>
            <p:cNvSpPr/>
            <p:nvPr/>
          </p:nvSpPr>
          <p:spPr>
            <a:xfrm flipH="1">
              <a:off x="6935400" y="1068480"/>
              <a:ext cx="71640" cy="1429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群組 168"/>
          <p:cNvGrpSpPr/>
          <p:nvPr/>
        </p:nvGrpSpPr>
        <p:grpSpPr>
          <a:xfrm>
            <a:off x="2298240" y="1041480"/>
            <a:ext cx="135000" cy="144360"/>
            <a:chOff x="2298240" y="1041480"/>
            <a:chExt cx="135000" cy="144360"/>
          </a:xfrm>
        </p:grpSpPr>
        <p:sp>
          <p:nvSpPr>
            <p:cNvPr id="64" name="直線接點 169"/>
            <p:cNvSpPr/>
            <p:nvPr/>
          </p:nvSpPr>
          <p:spPr>
            <a:xfrm flipH="1">
              <a:off x="2298240" y="1041480"/>
              <a:ext cx="7164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線接點 170"/>
            <p:cNvSpPr/>
            <p:nvPr/>
          </p:nvSpPr>
          <p:spPr>
            <a:xfrm flipH="1">
              <a:off x="2361600" y="1041480"/>
              <a:ext cx="7164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直線接點 172"/>
          <p:cNvSpPr/>
          <p:nvPr/>
        </p:nvSpPr>
        <p:spPr>
          <a:xfrm>
            <a:off x="7042320" y="1139760"/>
            <a:ext cx="180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接點 173"/>
          <p:cNvSpPr/>
          <p:nvPr/>
        </p:nvSpPr>
        <p:spPr>
          <a:xfrm>
            <a:off x="1695600" y="1130400"/>
            <a:ext cx="576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字方塊 174"/>
          <p:cNvSpPr/>
          <p:nvPr/>
        </p:nvSpPr>
        <p:spPr>
          <a:xfrm>
            <a:off x="1722240" y="1265400"/>
            <a:ext cx="79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p1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字方塊 175"/>
          <p:cNvSpPr/>
          <p:nvPr/>
        </p:nvSpPr>
        <p:spPr>
          <a:xfrm>
            <a:off x="1683000" y="2346480"/>
            <a:ext cx="2216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maltophilia </a:t>
            </a:r>
            <a:r>
              <a:rPr b="1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1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omosome before integr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手繪多邊形 180"/>
          <p:cNvSpPr/>
          <p:nvPr/>
        </p:nvSpPr>
        <p:spPr>
          <a:xfrm>
            <a:off x="1676520" y="762120"/>
            <a:ext cx="5591160" cy="393480"/>
          </a:xfrm>
          <a:custGeom>
            <a:avLst/>
            <a:gdLst/>
            <a:ahLst/>
            <a:rect l="l" t="t" r="r" b="b"/>
            <a:pathLst>
              <a:path w="6023631" h="1390810">
                <a:moveTo>
                  <a:pt x="25824" y="1375442"/>
                </a:moveTo>
                <a:cubicBezTo>
                  <a:pt x="39156" y="1095474"/>
                  <a:pt x="0" y="1282321"/>
                  <a:pt x="56560" y="1183341"/>
                </a:cubicBezTo>
                <a:cubicBezTo>
                  <a:pt x="75845" y="1149592"/>
                  <a:pt x="47520" y="1165864"/>
                  <a:pt x="87296" y="1152605"/>
                </a:cubicBezTo>
                <a:cubicBezTo>
                  <a:pt x="100820" y="1112032"/>
                  <a:pt x="90488" y="1136290"/>
                  <a:pt x="125716" y="1083449"/>
                </a:cubicBezTo>
                <a:lnTo>
                  <a:pt x="141085" y="1060397"/>
                </a:lnTo>
                <a:cubicBezTo>
                  <a:pt x="146367" y="1033987"/>
                  <a:pt x="149218" y="1016562"/>
                  <a:pt x="156453" y="991240"/>
                </a:cubicBezTo>
                <a:cubicBezTo>
                  <a:pt x="158678" y="983452"/>
                  <a:pt x="161576" y="975872"/>
                  <a:pt x="164137" y="968188"/>
                </a:cubicBezTo>
                <a:cubicBezTo>
                  <a:pt x="167388" y="942177"/>
                  <a:pt x="170344" y="885879"/>
                  <a:pt x="187189" y="860612"/>
                </a:cubicBezTo>
                <a:lnTo>
                  <a:pt x="202557" y="837560"/>
                </a:lnTo>
                <a:cubicBezTo>
                  <a:pt x="224617" y="749318"/>
                  <a:pt x="193771" y="858061"/>
                  <a:pt x="225609" y="783771"/>
                </a:cubicBezTo>
                <a:cubicBezTo>
                  <a:pt x="229769" y="774064"/>
                  <a:pt x="228570" y="762481"/>
                  <a:pt x="233293" y="753035"/>
                </a:cubicBezTo>
                <a:cubicBezTo>
                  <a:pt x="241553" y="736515"/>
                  <a:pt x="253784" y="722299"/>
                  <a:pt x="264029" y="706931"/>
                </a:cubicBezTo>
                <a:cubicBezTo>
                  <a:pt x="279397" y="683879"/>
                  <a:pt x="276836" y="681318"/>
                  <a:pt x="302449" y="668511"/>
                </a:cubicBezTo>
                <a:cubicBezTo>
                  <a:pt x="309694" y="664889"/>
                  <a:pt x="317817" y="663388"/>
                  <a:pt x="325501" y="660827"/>
                </a:cubicBezTo>
                <a:cubicBezTo>
                  <a:pt x="333185" y="653143"/>
                  <a:pt x="339859" y="644295"/>
                  <a:pt x="348553" y="637775"/>
                </a:cubicBezTo>
                <a:cubicBezTo>
                  <a:pt x="360501" y="628814"/>
                  <a:pt x="374309" y="622639"/>
                  <a:pt x="386974" y="614723"/>
                </a:cubicBezTo>
                <a:cubicBezTo>
                  <a:pt x="394805" y="609828"/>
                  <a:pt x="402342" y="604477"/>
                  <a:pt x="410026" y="599354"/>
                </a:cubicBezTo>
                <a:cubicBezTo>
                  <a:pt x="415149" y="591670"/>
                  <a:pt x="418183" y="582071"/>
                  <a:pt x="425394" y="576302"/>
                </a:cubicBezTo>
                <a:cubicBezTo>
                  <a:pt x="431719" y="571242"/>
                  <a:pt x="441001" y="571809"/>
                  <a:pt x="448446" y="568618"/>
                </a:cubicBezTo>
                <a:cubicBezTo>
                  <a:pt x="458974" y="564106"/>
                  <a:pt x="469169" y="558813"/>
                  <a:pt x="479182" y="553250"/>
                </a:cubicBezTo>
                <a:cubicBezTo>
                  <a:pt x="511739" y="535163"/>
                  <a:pt x="532013" y="520591"/>
                  <a:pt x="563706" y="499462"/>
                </a:cubicBezTo>
                <a:cubicBezTo>
                  <a:pt x="571390" y="494339"/>
                  <a:pt x="577998" y="487014"/>
                  <a:pt x="586759" y="484094"/>
                </a:cubicBezTo>
                <a:lnTo>
                  <a:pt x="609811" y="476410"/>
                </a:lnTo>
                <a:cubicBezTo>
                  <a:pt x="665974" y="438968"/>
                  <a:pt x="595356" y="484670"/>
                  <a:pt x="663599" y="445674"/>
                </a:cubicBezTo>
                <a:cubicBezTo>
                  <a:pt x="683029" y="434571"/>
                  <a:pt x="699062" y="420081"/>
                  <a:pt x="717387" y="407254"/>
                </a:cubicBezTo>
                <a:cubicBezTo>
                  <a:pt x="732518" y="396662"/>
                  <a:pt x="763491" y="376518"/>
                  <a:pt x="763491" y="376518"/>
                </a:cubicBezTo>
                <a:cubicBezTo>
                  <a:pt x="768614" y="368834"/>
                  <a:pt x="771175" y="358588"/>
                  <a:pt x="778859" y="353465"/>
                </a:cubicBezTo>
                <a:cubicBezTo>
                  <a:pt x="787646" y="347607"/>
                  <a:pt x="799707" y="349489"/>
                  <a:pt x="809595" y="345781"/>
                </a:cubicBezTo>
                <a:cubicBezTo>
                  <a:pt x="820321" y="341759"/>
                  <a:pt x="829803" y="334925"/>
                  <a:pt x="840332" y="330413"/>
                </a:cubicBezTo>
                <a:cubicBezTo>
                  <a:pt x="847777" y="327222"/>
                  <a:pt x="855700" y="325290"/>
                  <a:pt x="863384" y="322729"/>
                </a:cubicBezTo>
                <a:cubicBezTo>
                  <a:pt x="919547" y="285287"/>
                  <a:pt x="848929" y="330989"/>
                  <a:pt x="917172" y="291993"/>
                </a:cubicBezTo>
                <a:cubicBezTo>
                  <a:pt x="925190" y="287411"/>
                  <a:pt x="931463" y="279545"/>
                  <a:pt x="940224" y="276625"/>
                </a:cubicBezTo>
                <a:cubicBezTo>
                  <a:pt x="955004" y="271698"/>
                  <a:pt x="971051" y="271996"/>
                  <a:pt x="986328" y="268941"/>
                </a:cubicBezTo>
                <a:cubicBezTo>
                  <a:pt x="1015360" y="263135"/>
                  <a:pt x="1033767" y="255689"/>
                  <a:pt x="1063169" y="245889"/>
                </a:cubicBezTo>
                <a:cubicBezTo>
                  <a:pt x="1077950" y="240962"/>
                  <a:pt x="1093905" y="240766"/>
                  <a:pt x="1109273" y="238205"/>
                </a:cubicBezTo>
                <a:cubicBezTo>
                  <a:pt x="1164544" y="219781"/>
                  <a:pt x="1095522" y="242134"/>
                  <a:pt x="1163061" y="222837"/>
                </a:cubicBezTo>
                <a:cubicBezTo>
                  <a:pt x="1170849" y="220612"/>
                  <a:pt x="1178124" y="216485"/>
                  <a:pt x="1186113" y="215153"/>
                </a:cubicBezTo>
                <a:cubicBezTo>
                  <a:pt x="1208991" y="211340"/>
                  <a:pt x="1232308" y="210749"/>
                  <a:pt x="1255269" y="207469"/>
                </a:cubicBezTo>
                <a:cubicBezTo>
                  <a:pt x="1268198" y="205622"/>
                  <a:pt x="1280694" y="201085"/>
                  <a:pt x="1293690" y="199785"/>
                </a:cubicBezTo>
                <a:cubicBezTo>
                  <a:pt x="1332004" y="195954"/>
                  <a:pt x="1370530" y="194662"/>
                  <a:pt x="1408950" y="192101"/>
                </a:cubicBezTo>
                <a:cubicBezTo>
                  <a:pt x="1416634" y="189540"/>
                  <a:pt x="1424095" y="186174"/>
                  <a:pt x="1432002" y="184417"/>
                </a:cubicBezTo>
                <a:cubicBezTo>
                  <a:pt x="1477015" y="174414"/>
                  <a:pt x="1506357" y="175123"/>
                  <a:pt x="1554947" y="169049"/>
                </a:cubicBezTo>
                <a:cubicBezTo>
                  <a:pt x="1570407" y="167117"/>
                  <a:pt x="1585652" y="163734"/>
                  <a:pt x="1601051" y="161365"/>
                </a:cubicBezTo>
                <a:cubicBezTo>
                  <a:pt x="1618952" y="158611"/>
                  <a:pt x="1636910" y="156242"/>
                  <a:pt x="1654839" y="153681"/>
                </a:cubicBezTo>
                <a:cubicBezTo>
                  <a:pt x="1700202" y="130998"/>
                  <a:pt x="1687781" y="134102"/>
                  <a:pt x="1754732" y="122944"/>
                </a:cubicBezTo>
                <a:cubicBezTo>
                  <a:pt x="1834982" y="109569"/>
                  <a:pt x="1877413" y="106901"/>
                  <a:pt x="1954516" y="99892"/>
                </a:cubicBezTo>
                <a:cubicBezTo>
                  <a:pt x="2046799" y="69132"/>
                  <a:pt x="1940013" y="102632"/>
                  <a:pt x="2185037" y="76840"/>
                </a:cubicBezTo>
                <a:cubicBezTo>
                  <a:pt x="2213517" y="73842"/>
                  <a:pt x="2241315" y="66180"/>
                  <a:pt x="2269562" y="61472"/>
                </a:cubicBezTo>
                <a:cubicBezTo>
                  <a:pt x="2287427" y="58495"/>
                  <a:pt x="2305449" y="56542"/>
                  <a:pt x="2323350" y="53788"/>
                </a:cubicBezTo>
                <a:cubicBezTo>
                  <a:pt x="2338749" y="51419"/>
                  <a:pt x="2354086" y="48665"/>
                  <a:pt x="2369454" y="46104"/>
                </a:cubicBezTo>
                <a:lnTo>
                  <a:pt x="2415559" y="30736"/>
                </a:lnTo>
                <a:cubicBezTo>
                  <a:pt x="2423243" y="28175"/>
                  <a:pt x="2430753" y="25016"/>
                  <a:pt x="2438611" y="23052"/>
                </a:cubicBezTo>
                <a:cubicBezTo>
                  <a:pt x="2485063" y="11439"/>
                  <a:pt x="2459328" y="18708"/>
                  <a:pt x="2515451" y="0"/>
                </a:cubicBezTo>
                <a:lnTo>
                  <a:pt x="3022597" y="15368"/>
                </a:lnTo>
                <a:cubicBezTo>
                  <a:pt x="3184032" y="20935"/>
                  <a:pt x="3133775" y="10505"/>
                  <a:pt x="3214698" y="30736"/>
                </a:cubicBezTo>
                <a:lnTo>
                  <a:pt x="3660372" y="23052"/>
                </a:lnTo>
                <a:cubicBezTo>
                  <a:pt x="3775639" y="20814"/>
                  <a:pt x="3890864" y="15368"/>
                  <a:pt x="4006153" y="15368"/>
                </a:cubicBezTo>
                <a:cubicBezTo>
                  <a:pt x="4172660" y="15368"/>
                  <a:pt x="4339128" y="20491"/>
                  <a:pt x="4505616" y="23052"/>
                </a:cubicBezTo>
                <a:cubicBezTo>
                  <a:pt x="4527551" y="27439"/>
                  <a:pt x="4553069" y="31909"/>
                  <a:pt x="4574772" y="38420"/>
                </a:cubicBezTo>
                <a:cubicBezTo>
                  <a:pt x="4590288" y="43075"/>
                  <a:pt x="4604991" y="50611"/>
                  <a:pt x="4620876" y="53788"/>
                </a:cubicBezTo>
                <a:cubicBezTo>
                  <a:pt x="4633683" y="56349"/>
                  <a:pt x="4646547" y="58639"/>
                  <a:pt x="4659296" y="61472"/>
                </a:cubicBezTo>
                <a:cubicBezTo>
                  <a:pt x="4669605" y="63763"/>
                  <a:pt x="4679615" y="67420"/>
                  <a:pt x="4690032" y="69156"/>
                </a:cubicBezTo>
                <a:cubicBezTo>
                  <a:pt x="4746022" y="78488"/>
                  <a:pt x="4742920" y="72773"/>
                  <a:pt x="4789925" y="84524"/>
                </a:cubicBezTo>
                <a:cubicBezTo>
                  <a:pt x="4797783" y="86488"/>
                  <a:pt x="4805189" y="89983"/>
                  <a:pt x="4812977" y="92208"/>
                </a:cubicBezTo>
                <a:cubicBezTo>
                  <a:pt x="4823131" y="95109"/>
                  <a:pt x="4833468" y="97331"/>
                  <a:pt x="4843713" y="99892"/>
                </a:cubicBezTo>
                <a:cubicBezTo>
                  <a:pt x="4887649" y="129182"/>
                  <a:pt x="4849324" y="108596"/>
                  <a:pt x="4928237" y="122944"/>
                </a:cubicBezTo>
                <a:cubicBezTo>
                  <a:pt x="4936206" y="124393"/>
                  <a:pt x="4943475" y="128497"/>
                  <a:pt x="4951290" y="130628"/>
                </a:cubicBezTo>
                <a:cubicBezTo>
                  <a:pt x="4971667" y="136186"/>
                  <a:pt x="4992271" y="140874"/>
                  <a:pt x="5012762" y="145997"/>
                </a:cubicBezTo>
                <a:cubicBezTo>
                  <a:pt x="5038103" y="152333"/>
                  <a:pt x="5064822" y="153105"/>
                  <a:pt x="5089602" y="161365"/>
                </a:cubicBezTo>
                <a:cubicBezTo>
                  <a:pt x="5115272" y="169922"/>
                  <a:pt x="5114445" y="170301"/>
                  <a:pt x="5143390" y="176733"/>
                </a:cubicBezTo>
                <a:cubicBezTo>
                  <a:pt x="5156140" y="179566"/>
                  <a:pt x="5169211" y="180981"/>
                  <a:pt x="5181811" y="184417"/>
                </a:cubicBezTo>
                <a:cubicBezTo>
                  <a:pt x="5197440" y="188679"/>
                  <a:pt x="5227915" y="199785"/>
                  <a:pt x="5227915" y="199785"/>
                </a:cubicBezTo>
                <a:cubicBezTo>
                  <a:pt x="5233038" y="207469"/>
                  <a:pt x="5236753" y="216307"/>
                  <a:pt x="5243283" y="222837"/>
                </a:cubicBezTo>
                <a:cubicBezTo>
                  <a:pt x="5249813" y="229367"/>
                  <a:pt x="5258820" y="232837"/>
                  <a:pt x="5266335" y="238205"/>
                </a:cubicBezTo>
                <a:cubicBezTo>
                  <a:pt x="5276756" y="245649"/>
                  <a:pt x="5288015" y="252201"/>
                  <a:pt x="5297071" y="261257"/>
                </a:cubicBezTo>
                <a:cubicBezTo>
                  <a:pt x="5303601" y="267787"/>
                  <a:pt x="5306527" y="277214"/>
                  <a:pt x="5312439" y="284309"/>
                </a:cubicBezTo>
                <a:cubicBezTo>
                  <a:pt x="5319396" y="292657"/>
                  <a:pt x="5328419" y="299110"/>
                  <a:pt x="5335491" y="307361"/>
                </a:cubicBezTo>
                <a:cubicBezTo>
                  <a:pt x="5343825" y="317085"/>
                  <a:pt x="5349487" y="329041"/>
                  <a:pt x="5358543" y="338097"/>
                </a:cubicBezTo>
                <a:cubicBezTo>
                  <a:pt x="5365073" y="344627"/>
                  <a:pt x="5374693" y="347330"/>
                  <a:pt x="5381595" y="353465"/>
                </a:cubicBezTo>
                <a:cubicBezTo>
                  <a:pt x="5397839" y="367904"/>
                  <a:pt x="5409616" y="387514"/>
                  <a:pt x="5427700" y="399570"/>
                </a:cubicBezTo>
                <a:lnTo>
                  <a:pt x="5473804" y="430306"/>
                </a:lnTo>
                <a:cubicBezTo>
                  <a:pt x="5478927" y="437990"/>
                  <a:pt x="5485042" y="445098"/>
                  <a:pt x="5489172" y="453358"/>
                </a:cubicBezTo>
                <a:cubicBezTo>
                  <a:pt x="5492794" y="460603"/>
                  <a:pt x="5492363" y="469671"/>
                  <a:pt x="5496856" y="476410"/>
                </a:cubicBezTo>
                <a:cubicBezTo>
                  <a:pt x="5518486" y="508855"/>
                  <a:pt x="5535482" y="499668"/>
                  <a:pt x="5566012" y="530198"/>
                </a:cubicBezTo>
                <a:cubicBezTo>
                  <a:pt x="5584181" y="548367"/>
                  <a:pt x="5596798" y="563158"/>
                  <a:pt x="5619801" y="576302"/>
                </a:cubicBezTo>
                <a:cubicBezTo>
                  <a:pt x="5626833" y="580320"/>
                  <a:pt x="5635169" y="581425"/>
                  <a:pt x="5642853" y="583986"/>
                </a:cubicBezTo>
                <a:cubicBezTo>
                  <a:pt x="5658221" y="594232"/>
                  <a:pt x="5678712" y="599355"/>
                  <a:pt x="5688957" y="614723"/>
                </a:cubicBezTo>
                <a:cubicBezTo>
                  <a:pt x="5710353" y="646817"/>
                  <a:pt x="5697795" y="631245"/>
                  <a:pt x="5727377" y="660827"/>
                </a:cubicBezTo>
                <a:cubicBezTo>
                  <a:pt x="5742336" y="705704"/>
                  <a:pt x="5723356" y="664490"/>
                  <a:pt x="5758113" y="699247"/>
                </a:cubicBezTo>
                <a:cubicBezTo>
                  <a:pt x="5815299" y="756433"/>
                  <a:pt x="5749890" y="709133"/>
                  <a:pt x="5804217" y="745351"/>
                </a:cubicBezTo>
                <a:cubicBezTo>
                  <a:pt x="5809340" y="753035"/>
                  <a:pt x="5813504" y="761453"/>
                  <a:pt x="5819585" y="768403"/>
                </a:cubicBezTo>
                <a:cubicBezTo>
                  <a:pt x="5831512" y="782033"/>
                  <a:pt x="5847960" y="791753"/>
                  <a:pt x="5858006" y="806823"/>
                </a:cubicBezTo>
                <a:lnTo>
                  <a:pt x="5888742" y="852928"/>
                </a:lnTo>
                <a:lnTo>
                  <a:pt x="5919478" y="899032"/>
                </a:lnTo>
                <a:lnTo>
                  <a:pt x="5934846" y="922084"/>
                </a:lnTo>
                <a:cubicBezTo>
                  <a:pt x="5955172" y="1003390"/>
                  <a:pt x="5927575" y="907646"/>
                  <a:pt x="5957898" y="975872"/>
                </a:cubicBezTo>
                <a:cubicBezTo>
                  <a:pt x="5964477" y="990675"/>
                  <a:pt x="5968143" y="1006608"/>
                  <a:pt x="5973266" y="1021976"/>
                </a:cubicBezTo>
                <a:lnTo>
                  <a:pt x="5988634" y="1068081"/>
                </a:lnTo>
                <a:cubicBezTo>
                  <a:pt x="5991195" y="1075765"/>
                  <a:pt x="5994354" y="1083275"/>
                  <a:pt x="5996318" y="1091133"/>
                </a:cubicBezTo>
                <a:cubicBezTo>
                  <a:pt x="6005966" y="1129727"/>
                  <a:pt x="6000662" y="1111850"/>
                  <a:pt x="6011686" y="1144921"/>
                </a:cubicBezTo>
                <a:cubicBezTo>
                  <a:pt x="6021280" y="1212079"/>
                  <a:pt x="6023631" y="1197903"/>
                  <a:pt x="6011686" y="1275549"/>
                </a:cubicBezTo>
                <a:cubicBezTo>
                  <a:pt x="6010454" y="1283555"/>
                  <a:pt x="6007936" y="1291521"/>
                  <a:pt x="6004002" y="1298602"/>
                </a:cubicBezTo>
                <a:cubicBezTo>
                  <a:pt x="5995032" y="1314748"/>
                  <a:pt x="5979107" y="1327184"/>
                  <a:pt x="5973266" y="1344706"/>
                </a:cubicBezTo>
                <a:cubicBezTo>
                  <a:pt x="5970705" y="1352390"/>
                  <a:pt x="5970075" y="1361019"/>
                  <a:pt x="5965582" y="1367758"/>
                </a:cubicBezTo>
                <a:cubicBezTo>
                  <a:pt x="5959554" y="1376800"/>
                  <a:pt x="5942530" y="1390810"/>
                  <a:pt x="5942530" y="1390810"/>
                </a:cubicBez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字方塊 387"/>
          <p:cNvSpPr/>
          <p:nvPr/>
        </p:nvSpPr>
        <p:spPr>
          <a:xfrm>
            <a:off x="1074600" y="1698480"/>
            <a:ext cx="64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字方塊 387"/>
          <p:cNvSpPr/>
          <p:nvPr/>
        </p:nvSpPr>
        <p:spPr>
          <a:xfrm>
            <a:off x="1074600" y="473040"/>
            <a:ext cx="648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7"/>
          <p:cNvSpPr/>
          <p:nvPr/>
        </p:nvSpPr>
        <p:spPr>
          <a:xfrm>
            <a:off x="1363680" y="4195800"/>
            <a:ext cx="1187280" cy="34920"/>
          </a:xfrm>
          <a:prstGeom prst="rect">
            <a:avLst/>
          </a:prstGeom>
          <a:solidFill>
            <a:srgbClr val="7f7f7f"/>
          </a:solidFill>
          <a:ln w="3240">
            <a:solidFill>
              <a:srgbClr val="cccc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"/>
          <p:cNvSpPr/>
          <p:nvPr/>
        </p:nvSpPr>
        <p:spPr>
          <a:xfrm>
            <a:off x="6337440" y="4195800"/>
            <a:ext cx="1187280" cy="34920"/>
          </a:xfrm>
          <a:prstGeom prst="rect">
            <a:avLst/>
          </a:prstGeom>
          <a:solidFill>
            <a:srgbClr val="7f7f7f"/>
          </a:solidFill>
          <a:ln w="3240">
            <a:solidFill>
              <a:srgbClr val="cccc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7"/>
          <p:cNvSpPr/>
          <p:nvPr/>
        </p:nvSpPr>
        <p:spPr>
          <a:xfrm>
            <a:off x="4645080" y="4187880"/>
            <a:ext cx="169236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cccc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6"/>
          <p:cNvSpPr/>
          <p:nvPr/>
        </p:nvSpPr>
        <p:spPr>
          <a:xfrm>
            <a:off x="2031840" y="4192560"/>
            <a:ext cx="5040" cy="34920"/>
          </a:xfrm>
          <a:prstGeom prst="rect">
            <a:avLst/>
          </a:prstGeom>
          <a:solidFill>
            <a:srgbClr val="ffffcc"/>
          </a:solidFill>
          <a:ln w="3240">
            <a:solidFill>
              <a:srgbClr val="cccc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7"/>
          <p:cNvSpPr/>
          <p:nvPr/>
        </p:nvSpPr>
        <p:spPr>
          <a:xfrm>
            <a:off x="2557440" y="4192560"/>
            <a:ext cx="1979640" cy="34920"/>
          </a:xfrm>
          <a:prstGeom prst="rect">
            <a:avLst/>
          </a:prstGeom>
          <a:solidFill>
            <a:srgbClr val="000000"/>
          </a:solidFill>
          <a:ln w="3240">
            <a:solidFill>
              <a:srgbClr val="cccc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10"/>
          <p:cNvSpPr/>
          <p:nvPr/>
        </p:nvSpPr>
        <p:spPr>
          <a:xfrm>
            <a:off x="4952880" y="4094280"/>
            <a:ext cx="303480" cy="233280"/>
          </a:xfrm>
          <a:custGeom>
            <a:avLst/>
            <a:gdLst>
              <a:gd name="textAreaLeft" fmla="*/ 0 w 303480"/>
              <a:gd name="textAreaRight" fmla="*/ 303840 w 30348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191" h="147">
                <a:moveTo>
                  <a:pt x="126" y="147"/>
                </a:moveTo>
                <a:lnTo>
                  <a:pt x="191" y="73"/>
                </a:lnTo>
                <a:lnTo>
                  <a:pt x="126" y="0"/>
                </a:lnTo>
                <a:lnTo>
                  <a:pt x="126" y="33"/>
                </a:lnTo>
                <a:lnTo>
                  <a:pt x="0" y="33"/>
                </a:lnTo>
                <a:lnTo>
                  <a:pt x="0" y="114"/>
                </a:lnTo>
                <a:lnTo>
                  <a:pt x="126" y="114"/>
                </a:lnTo>
                <a:lnTo>
                  <a:pt x="126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2"/>
          <p:cNvSpPr/>
          <p:nvPr/>
        </p:nvSpPr>
        <p:spPr>
          <a:xfrm>
            <a:off x="4932000" y="43117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f4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5"/>
          <p:cNvSpPr/>
          <p:nvPr/>
        </p:nvSpPr>
        <p:spPr>
          <a:xfrm>
            <a:off x="6373440" y="4395960"/>
            <a:ext cx="217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t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8"/>
          <p:cNvSpPr/>
          <p:nvPr/>
        </p:nvSpPr>
        <p:spPr>
          <a:xfrm>
            <a:off x="5986800" y="3713040"/>
            <a:ext cx="140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21"/>
          <p:cNvSpPr/>
          <p:nvPr/>
        </p:nvSpPr>
        <p:spPr>
          <a:xfrm>
            <a:off x="6250320" y="3792600"/>
            <a:ext cx="140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24"/>
          <p:cNvSpPr/>
          <p:nvPr/>
        </p:nvSpPr>
        <p:spPr>
          <a:xfrm>
            <a:off x="6278760" y="3362400"/>
            <a:ext cx="140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28"/>
          <p:cNvSpPr/>
          <p:nvPr/>
        </p:nvSpPr>
        <p:spPr>
          <a:xfrm>
            <a:off x="5256360" y="4095720"/>
            <a:ext cx="933480" cy="233280"/>
          </a:xfrm>
          <a:custGeom>
            <a:avLst/>
            <a:gdLst>
              <a:gd name="textAreaLeft" fmla="*/ 0 w 933480"/>
              <a:gd name="textAreaRight" fmla="*/ 933840 w 93348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588" h="147">
                <a:moveTo>
                  <a:pt x="523" y="147"/>
                </a:moveTo>
                <a:lnTo>
                  <a:pt x="588" y="74"/>
                </a:lnTo>
                <a:lnTo>
                  <a:pt x="523" y="0"/>
                </a:lnTo>
                <a:lnTo>
                  <a:pt x="523" y="33"/>
                </a:lnTo>
                <a:lnTo>
                  <a:pt x="0" y="33"/>
                </a:lnTo>
                <a:lnTo>
                  <a:pt x="0" y="115"/>
                </a:lnTo>
                <a:lnTo>
                  <a:pt x="523" y="115"/>
                </a:lnTo>
                <a:lnTo>
                  <a:pt x="523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30"/>
          <p:cNvSpPr/>
          <p:nvPr/>
        </p:nvSpPr>
        <p:spPr>
          <a:xfrm>
            <a:off x="5537880" y="41432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34"/>
          <p:cNvSpPr/>
          <p:nvPr/>
        </p:nvSpPr>
        <p:spPr>
          <a:xfrm>
            <a:off x="4056120" y="4092480"/>
            <a:ext cx="179280" cy="233280"/>
          </a:xfrm>
          <a:custGeom>
            <a:avLst/>
            <a:gdLst>
              <a:gd name="textAreaLeft" fmla="*/ 0 w 179280"/>
              <a:gd name="textAreaRight" fmla="*/ 179280 w 17928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225" h="147">
                <a:moveTo>
                  <a:pt x="159" y="147"/>
                </a:moveTo>
                <a:lnTo>
                  <a:pt x="225" y="73"/>
                </a:lnTo>
                <a:lnTo>
                  <a:pt x="159" y="0"/>
                </a:lnTo>
                <a:lnTo>
                  <a:pt x="159" y="33"/>
                </a:lnTo>
                <a:lnTo>
                  <a:pt x="0" y="33"/>
                </a:lnTo>
                <a:lnTo>
                  <a:pt x="0" y="114"/>
                </a:lnTo>
                <a:lnTo>
                  <a:pt x="159" y="114"/>
                </a:lnTo>
                <a:lnTo>
                  <a:pt x="159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6"/>
          <p:cNvSpPr/>
          <p:nvPr/>
        </p:nvSpPr>
        <p:spPr>
          <a:xfrm>
            <a:off x="3997080" y="38926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f4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37"/>
          <p:cNvSpPr/>
          <p:nvPr/>
        </p:nvSpPr>
        <p:spPr>
          <a:xfrm>
            <a:off x="3478320" y="4095720"/>
            <a:ext cx="528480" cy="233280"/>
          </a:xfrm>
          <a:custGeom>
            <a:avLst/>
            <a:gdLst>
              <a:gd name="textAreaLeft" fmla="*/ 0 w 528480"/>
              <a:gd name="textAreaRight" fmla="*/ 528840 w 52848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33" h="147">
                <a:moveTo>
                  <a:pt x="267" y="147"/>
                </a:moveTo>
                <a:lnTo>
                  <a:pt x="333" y="74"/>
                </a:lnTo>
                <a:lnTo>
                  <a:pt x="267" y="0"/>
                </a:lnTo>
                <a:lnTo>
                  <a:pt x="267" y="33"/>
                </a:lnTo>
                <a:lnTo>
                  <a:pt x="0" y="33"/>
                </a:lnTo>
                <a:lnTo>
                  <a:pt x="0" y="115"/>
                </a:lnTo>
                <a:lnTo>
                  <a:pt x="267" y="115"/>
                </a:lnTo>
                <a:lnTo>
                  <a:pt x="267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9"/>
          <p:cNvSpPr/>
          <p:nvPr/>
        </p:nvSpPr>
        <p:spPr>
          <a:xfrm>
            <a:off x="3583440" y="41450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40"/>
          <p:cNvSpPr/>
          <p:nvPr/>
        </p:nvSpPr>
        <p:spPr>
          <a:xfrm>
            <a:off x="2727360" y="4094280"/>
            <a:ext cx="711000" cy="233280"/>
          </a:xfrm>
          <a:custGeom>
            <a:avLst/>
            <a:gdLst>
              <a:gd name="textAreaLeft" fmla="*/ 0 w 711000"/>
              <a:gd name="textAreaRight" fmla="*/ 711360 w 71100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448" h="147">
                <a:moveTo>
                  <a:pt x="382" y="147"/>
                </a:moveTo>
                <a:lnTo>
                  <a:pt x="448" y="73"/>
                </a:lnTo>
                <a:lnTo>
                  <a:pt x="382" y="0"/>
                </a:lnTo>
                <a:lnTo>
                  <a:pt x="382" y="33"/>
                </a:lnTo>
                <a:lnTo>
                  <a:pt x="0" y="33"/>
                </a:lnTo>
                <a:lnTo>
                  <a:pt x="0" y="114"/>
                </a:lnTo>
                <a:lnTo>
                  <a:pt x="382" y="114"/>
                </a:lnTo>
                <a:lnTo>
                  <a:pt x="382" y="147"/>
                </a:lnTo>
                <a:close/>
              </a:path>
            </a:pathLst>
          </a:custGeom>
          <a:solidFill>
            <a:srgbClr val="7f7f7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2"/>
          <p:cNvSpPr/>
          <p:nvPr/>
        </p:nvSpPr>
        <p:spPr>
          <a:xfrm>
            <a:off x="2886480" y="41432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orf4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45"/>
          <p:cNvSpPr/>
          <p:nvPr/>
        </p:nvSpPr>
        <p:spPr>
          <a:xfrm rot="16200000">
            <a:off x="2476440" y="4376880"/>
            <a:ext cx="210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t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46"/>
          <p:cNvSpPr/>
          <p:nvPr/>
        </p:nvSpPr>
        <p:spPr>
          <a:xfrm>
            <a:off x="6269040" y="4086360"/>
            <a:ext cx="61920" cy="233280"/>
          </a:xfrm>
          <a:custGeom>
            <a:avLst/>
            <a:gdLst>
              <a:gd name="textAreaLeft" fmla="*/ 0 w 61920"/>
              <a:gd name="textAreaRight" fmla="*/ 62280 w 6192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9" h="147">
                <a:moveTo>
                  <a:pt x="39" y="33"/>
                </a:moveTo>
                <a:lnTo>
                  <a:pt x="29" y="33"/>
                </a:lnTo>
                <a:lnTo>
                  <a:pt x="29" y="0"/>
                </a:lnTo>
                <a:lnTo>
                  <a:pt x="0" y="74"/>
                </a:lnTo>
                <a:lnTo>
                  <a:pt x="29" y="147"/>
                </a:lnTo>
                <a:lnTo>
                  <a:pt x="29" y="115"/>
                </a:lnTo>
                <a:lnTo>
                  <a:pt x="39" y="115"/>
                </a:lnTo>
                <a:lnTo>
                  <a:pt x="39" y="33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48"/>
          <p:cNvSpPr/>
          <p:nvPr/>
        </p:nvSpPr>
        <p:spPr>
          <a:xfrm>
            <a:off x="6373800" y="4253040"/>
            <a:ext cx="51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NA-Th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46"/>
          <p:cNvSpPr/>
          <p:nvPr/>
        </p:nvSpPr>
        <p:spPr>
          <a:xfrm>
            <a:off x="6272280" y="4344840"/>
            <a:ext cx="28440" cy="233640"/>
          </a:xfrm>
          <a:custGeom>
            <a:avLst/>
            <a:gdLst>
              <a:gd name="textAreaLeft" fmla="*/ 0 w 28440"/>
              <a:gd name="textAreaRight" fmla="*/ 28800 w 28440"/>
              <a:gd name="textAreaTop" fmla="*/ 0 h 233640"/>
              <a:gd name="textAreaBottom" fmla="*/ 234000 h 233640"/>
            </a:gdLst>
            <a:ahLst/>
            <a:rect l="textAreaLeft" t="textAreaTop" r="textAreaRight" b="textAreaBottom"/>
            <a:pathLst>
              <a:path w="39" h="147">
                <a:moveTo>
                  <a:pt x="39" y="33"/>
                </a:moveTo>
                <a:lnTo>
                  <a:pt x="29" y="33"/>
                </a:lnTo>
                <a:lnTo>
                  <a:pt x="29" y="0"/>
                </a:lnTo>
                <a:lnTo>
                  <a:pt x="0" y="74"/>
                </a:lnTo>
                <a:lnTo>
                  <a:pt x="29" y="147"/>
                </a:lnTo>
                <a:lnTo>
                  <a:pt x="29" y="115"/>
                </a:lnTo>
                <a:lnTo>
                  <a:pt x="39" y="115"/>
                </a:lnTo>
                <a:lnTo>
                  <a:pt x="39" y="33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46"/>
          <p:cNvSpPr/>
          <p:nvPr/>
        </p:nvSpPr>
        <p:spPr>
          <a:xfrm>
            <a:off x="2557440" y="4094280"/>
            <a:ext cx="28440" cy="233280"/>
          </a:xfrm>
          <a:custGeom>
            <a:avLst/>
            <a:gdLst>
              <a:gd name="textAreaLeft" fmla="*/ 0 w 28440"/>
              <a:gd name="textAreaRight" fmla="*/ 28800 w 2844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39" h="147">
                <a:moveTo>
                  <a:pt x="39" y="33"/>
                </a:moveTo>
                <a:lnTo>
                  <a:pt x="29" y="33"/>
                </a:lnTo>
                <a:lnTo>
                  <a:pt x="29" y="0"/>
                </a:lnTo>
                <a:lnTo>
                  <a:pt x="0" y="74"/>
                </a:lnTo>
                <a:lnTo>
                  <a:pt x="29" y="147"/>
                </a:lnTo>
                <a:lnTo>
                  <a:pt x="29" y="115"/>
                </a:lnTo>
                <a:lnTo>
                  <a:pt x="39" y="115"/>
                </a:lnTo>
                <a:lnTo>
                  <a:pt x="39" y="33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群組 150"/>
          <p:cNvGrpSpPr/>
          <p:nvPr/>
        </p:nvGrpSpPr>
        <p:grpSpPr>
          <a:xfrm>
            <a:off x="6172200" y="3678120"/>
            <a:ext cx="73080" cy="513000"/>
            <a:chOff x="6172200" y="3678120"/>
            <a:chExt cx="73080" cy="513000"/>
          </a:xfrm>
        </p:grpSpPr>
        <p:sp>
          <p:nvSpPr>
            <p:cNvPr id="98" name="橢圓 196"/>
            <p:cNvSpPr/>
            <p:nvPr/>
          </p:nvSpPr>
          <p:spPr>
            <a:xfrm>
              <a:off x="6172200" y="3678120"/>
              <a:ext cx="7308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直線接點 197"/>
            <p:cNvSpPr/>
            <p:nvPr/>
          </p:nvSpPr>
          <p:spPr>
            <a:xfrm>
              <a:off x="6208560" y="3759120"/>
              <a:ext cx="0" cy="43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群組 130"/>
          <p:cNvGrpSpPr/>
          <p:nvPr/>
        </p:nvGrpSpPr>
        <p:grpSpPr>
          <a:xfrm>
            <a:off x="5955840" y="3892320"/>
            <a:ext cx="145080" cy="216000"/>
            <a:chOff x="5955840" y="3892320"/>
            <a:chExt cx="145080" cy="216000"/>
          </a:xfrm>
        </p:grpSpPr>
        <p:sp>
          <p:nvSpPr>
            <p:cNvPr id="101" name="直線接點 194"/>
            <p:cNvSpPr/>
            <p:nvPr/>
          </p:nvSpPr>
          <p:spPr>
            <a:xfrm>
              <a:off x="6100920" y="3892680"/>
              <a:ext cx="0" cy="21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2" name="直線單箭頭接點 195"/>
            <p:cNvCxnSpPr/>
            <p:nvPr/>
          </p:nvCxnSpPr>
          <p:spPr>
            <a:xfrm flipH="1" flipV="1">
              <a:off x="5955840" y="3892320"/>
              <a:ext cx="14544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103" name="群組 130"/>
          <p:cNvGrpSpPr/>
          <p:nvPr/>
        </p:nvGrpSpPr>
        <p:grpSpPr>
          <a:xfrm>
            <a:off x="6206760" y="3531600"/>
            <a:ext cx="201960" cy="649800"/>
            <a:chOff x="6206760" y="3531600"/>
            <a:chExt cx="201960" cy="649800"/>
          </a:xfrm>
        </p:grpSpPr>
        <p:sp>
          <p:nvSpPr>
            <p:cNvPr id="104" name="直線接點 192"/>
            <p:cNvSpPr/>
            <p:nvPr/>
          </p:nvSpPr>
          <p:spPr>
            <a:xfrm>
              <a:off x="6408720" y="3532320"/>
              <a:ext cx="0" cy="64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5" name="直線單箭頭接點 193"/>
            <p:cNvCxnSpPr/>
            <p:nvPr/>
          </p:nvCxnSpPr>
          <p:spPr>
            <a:xfrm flipH="1" flipV="1">
              <a:off x="6206760" y="3531600"/>
              <a:ext cx="202320" cy="5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106" name="群組 134"/>
          <p:cNvGrpSpPr/>
          <p:nvPr/>
        </p:nvGrpSpPr>
        <p:grpSpPr>
          <a:xfrm>
            <a:off x="6240240" y="3965040"/>
            <a:ext cx="144720" cy="216360"/>
            <a:chOff x="6240240" y="3965040"/>
            <a:chExt cx="144720" cy="216360"/>
          </a:xfrm>
        </p:grpSpPr>
        <p:sp>
          <p:nvSpPr>
            <p:cNvPr id="107" name="直線接點 190"/>
            <p:cNvSpPr/>
            <p:nvPr/>
          </p:nvSpPr>
          <p:spPr>
            <a:xfrm>
              <a:off x="6240240" y="396540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8" name="直線單箭頭接點 191"/>
            <p:cNvCxnSpPr/>
            <p:nvPr/>
          </p:nvCxnSpPr>
          <p:spPr>
            <a:xfrm flipV="1">
              <a:off x="6240600" y="3965040"/>
              <a:ext cx="14472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109" name="Line 239"/>
          <p:cNvSpPr/>
          <p:nvPr/>
        </p:nvSpPr>
        <p:spPr>
          <a:xfrm>
            <a:off x="5769000" y="3895560"/>
            <a:ext cx="1440" cy="247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42"/>
          <p:cNvSpPr/>
          <p:nvPr/>
        </p:nvSpPr>
        <p:spPr>
          <a:xfrm rot="16200000">
            <a:off x="5632920" y="3674520"/>
            <a:ext cx="250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e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39"/>
          <p:cNvSpPr/>
          <p:nvPr/>
        </p:nvSpPr>
        <p:spPr>
          <a:xfrm>
            <a:off x="6446880" y="3933720"/>
            <a:ext cx="1440" cy="247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42"/>
          <p:cNvSpPr/>
          <p:nvPr/>
        </p:nvSpPr>
        <p:spPr>
          <a:xfrm rot="16200000">
            <a:off x="6366600" y="3711600"/>
            <a:ext cx="250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e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群組 400"/>
          <p:cNvGrpSpPr/>
          <p:nvPr/>
        </p:nvGrpSpPr>
        <p:grpSpPr>
          <a:xfrm>
            <a:off x="2580840" y="3930120"/>
            <a:ext cx="144720" cy="216360"/>
            <a:chOff x="2580840" y="3930120"/>
            <a:chExt cx="144720" cy="216360"/>
          </a:xfrm>
        </p:grpSpPr>
        <p:sp>
          <p:nvSpPr>
            <p:cNvPr id="114" name="直線接點 188"/>
            <p:cNvSpPr/>
            <p:nvPr/>
          </p:nvSpPr>
          <p:spPr>
            <a:xfrm>
              <a:off x="2725560" y="393048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5" name="直線單箭頭接點 189"/>
            <p:cNvCxnSpPr/>
            <p:nvPr/>
          </p:nvCxnSpPr>
          <p:spPr>
            <a:xfrm flipH="1" flipV="1">
              <a:off x="2580840" y="3930120"/>
              <a:ext cx="14472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116" name="文字方塊 401"/>
          <p:cNvSpPr/>
          <p:nvPr/>
        </p:nvSpPr>
        <p:spPr>
          <a:xfrm>
            <a:off x="2534040" y="3720960"/>
            <a:ext cx="31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7" name="群組 402"/>
          <p:cNvGrpSpPr/>
          <p:nvPr/>
        </p:nvGrpSpPr>
        <p:grpSpPr>
          <a:xfrm>
            <a:off x="3098520" y="3920760"/>
            <a:ext cx="144720" cy="216360"/>
            <a:chOff x="3098520" y="3920760"/>
            <a:chExt cx="144720" cy="216360"/>
          </a:xfrm>
        </p:grpSpPr>
        <p:sp>
          <p:nvSpPr>
            <p:cNvPr id="118" name="直線接點 186"/>
            <p:cNvSpPr/>
            <p:nvPr/>
          </p:nvSpPr>
          <p:spPr>
            <a:xfrm>
              <a:off x="3098520" y="392112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9" name="直線單箭頭接點 187"/>
            <p:cNvCxnSpPr/>
            <p:nvPr/>
          </p:nvCxnSpPr>
          <p:spPr>
            <a:xfrm flipV="1">
              <a:off x="3098880" y="3920760"/>
              <a:ext cx="14472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120" name="文字方塊 405"/>
          <p:cNvSpPr/>
          <p:nvPr/>
        </p:nvSpPr>
        <p:spPr>
          <a:xfrm>
            <a:off x="3023640" y="3714840"/>
            <a:ext cx="31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1" name="群組 121"/>
          <p:cNvGrpSpPr/>
          <p:nvPr/>
        </p:nvGrpSpPr>
        <p:grpSpPr>
          <a:xfrm>
            <a:off x="3131640" y="3603240"/>
            <a:ext cx="194040" cy="540000"/>
            <a:chOff x="3131640" y="3603240"/>
            <a:chExt cx="194040" cy="540000"/>
          </a:xfrm>
        </p:grpSpPr>
        <p:sp>
          <p:nvSpPr>
            <p:cNvPr id="122" name="直線接點 176"/>
            <p:cNvSpPr/>
            <p:nvPr/>
          </p:nvSpPr>
          <p:spPr>
            <a:xfrm>
              <a:off x="3325680" y="3603600"/>
              <a:ext cx="0" cy="53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3" name="直線單箭頭接點 179"/>
            <p:cNvCxnSpPr/>
            <p:nvPr/>
          </p:nvCxnSpPr>
          <p:spPr>
            <a:xfrm flipH="1" flipV="1">
              <a:off x="3131640" y="3603240"/>
              <a:ext cx="19440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124" name="文字方塊 124"/>
          <p:cNvSpPr/>
          <p:nvPr/>
        </p:nvSpPr>
        <p:spPr>
          <a:xfrm>
            <a:off x="3153960" y="3425760"/>
            <a:ext cx="31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239"/>
          <p:cNvSpPr/>
          <p:nvPr/>
        </p:nvSpPr>
        <p:spPr>
          <a:xfrm>
            <a:off x="3260880" y="4278240"/>
            <a:ext cx="1440" cy="108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242"/>
          <p:cNvSpPr/>
          <p:nvPr/>
        </p:nvSpPr>
        <p:spPr>
          <a:xfrm rot="16200000">
            <a:off x="3111480" y="446364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ncI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" name="群組 126"/>
          <p:cNvGrpSpPr/>
          <p:nvPr/>
        </p:nvGrpSpPr>
        <p:grpSpPr>
          <a:xfrm>
            <a:off x="2063520" y="3978000"/>
            <a:ext cx="144720" cy="217800"/>
            <a:chOff x="2063520" y="3978000"/>
            <a:chExt cx="144720" cy="217800"/>
          </a:xfrm>
        </p:grpSpPr>
        <p:sp>
          <p:nvSpPr>
            <p:cNvPr id="128" name="直線接點 174"/>
            <p:cNvSpPr/>
            <p:nvPr/>
          </p:nvSpPr>
          <p:spPr>
            <a:xfrm>
              <a:off x="2063520" y="3978360"/>
              <a:ext cx="0" cy="21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9" name="直線單箭頭接點 175"/>
            <p:cNvCxnSpPr/>
            <p:nvPr/>
          </p:nvCxnSpPr>
          <p:spPr>
            <a:xfrm flipV="1">
              <a:off x="2063880" y="3978000"/>
              <a:ext cx="14472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130" name="文字方塊 129"/>
          <p:cNvSpPr/>
          <p:nvPr/>
        </p:nvSpPr>
        <p:spPr>
          <a:xfrm>
            <a:off x="1979280" y="3770280"/>
            <a:ext cx="31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239"/>
          <p:cNvSpPr/>
          <p:nvPr/>
        </p:nvSpPr>
        <p:spPr>
          <a:xfrm>
            <a:off x="2036880" y="4237200"/>
            <a:ext cx="1440" cy="109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242"/>
          <p:cNvSpPr/>
          <p:nvPr/>
        </p:nvSpPr>
        <p:spPr>
          <a:xfrm rot="16200000">
            <a:off x="1887480" y="443124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ncI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群組 176"/>
          <p:cNvGrpSpPr/>
          <p:nvPr/>
        </p:nvGrpSpPr>
        <p:grpSpPr>
          <a:xfrm>
            <a:off x="4509720" y="4137120"/>
            <a:ext cx="135000" cy="144360"/>
            <a:chOff x="4509720" y="4137120"/>
            <a:chExt cx="135000" cy="144360"/>
          </a:xfrm>
        </p:grpSpPr>
        <p:sp>
          <p:nvSpPr>
            <p:cNvPr id="134" name="直線接點 168"/>
            <p:cNvSpPr/>
            <p:nvPr/>
          </p:nvSpPr>
          <p:spPr>
            <a:xfrm flipH="1">
              <a:off x="4509720" y="4137120"/>
              <a:ext cx="7164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直線接點 171"/>
            <p:cNvSpPr/>
            <p:nvPr/>
          </p:nvSpPr>
          <p:spPr>
            <a:xfrm flipH="1">
              <a:off x="4573080" y="4137120"/>
              <a:ext cx="7164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" name=""/>
          <p:cNvSpPr/>
          <p:nvPr/>
        </p:nvSpPr>
        <p:spPr>
          <a:xfrm>
            <a:off x="457200" y="4800600"/>
            <a:ext cx="838188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Times New Roman"/>
              </a:rPr>
              <a:t>Figure S4  Strategy for cloning the host-prophage junctions from Smp131-lysogenized </a:t>
            </a:r>
            <a:r>
              <a:rPr b="1" i="1" lang="zh-TW" sz="1200" spc="-1" strike="noStrike">
                <a:solidFill>
                  <a:srgbClr val="000000"/>
                </a:solidFill>
                <a:latin typeface="Times New Roman"/>
              </a:rPr>
              <a:t>S. maltophilia </a:t>
            </a:r>
            <a:r>
              <a:rPr b="1" lang="zh-TW" sz="1200" spc="-1" strike="noStrike">
                <a:solidFill>
                  <a:srgbClr val="000000"/>
                </a:solidFill>
                <a:latin typeface="Times New Roman"/>
              </a:rPr>
              <a:t>T13. 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(A) Sketch depicting the circular Smp131 genome and genes near the predicted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attP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site.  Arrows represent the genes and predicted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attP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site. (B) Sketch showing the host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S. maltophili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T13 chromosome and its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attB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site. (C) Map showing relative positions of genes after Smp131 integration into host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S. maltophili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T13.  Primers used in PCR were: L1; 5’-TGAAAGGTGCCATGACCACACG-3’; L2, 5’-GCGTTGCCAAGGTCAGATCGG-3’; L3; 5’-CGCATCGCACTCTAGGAAGTGAAG-3’; L4, 5’-AACTGCCAGAACCTCTGCAGTG-3’; R1, 5’-CTCTTGTCCTCGCTGTCGGT-3’; R2, 5’-TGATAGCCCTATTTTCAAGGGC-3’; R3, 5’-AGGCCCAGCAGCGCA-3’; R4, 5’-TGCCTGCCGCCAGCT-3’.  </a:t>
            </a:r>
            <a:r>
              <a:rPr b="0" i="1" lang="zh-TW" sz="1200" spc="-1" strike="noStrike">
                <a:solidFill>
                  <a:srgbClr val="000000"/>
                </a:solidFill>
                <a:latin typeface="Times New Roman"/>
              </a:rPr>
              <a:t>S. maltophili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T13 chromosome containing prophage Smp131 was digested with HincII and NaeI.  The fragments were self-ligated and the circularized DNA was then used as the templates for inverse PCR.  Amplicons obtained were sequenced for comparis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ser</cp:lastModifiedBy>
  <dcterms:modified xsi:type="dcterms:W3CDTF">2014-01-12T09:54:15Z</dcterms:modified>
  <cp:revision>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